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drawings/drawing2.xml" ContentType="application/vnd.openxmlformats-officedocument.drawingml.chartshapes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9" r:id="rId5"/>
    <p:sldId id="257" r:id="rId6"/>
    <p:sldId id="265" r:id="rId7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ophie BOZEC" initials="SB" lastIdx="16" clrIdx="0">
    <p:extLst>
      <p:ext uri="{19B8F6BF-5375-455C-9EA6-DF929625EA0E}">
        <p15:presenceInfo xmlns:p15="http://schemas.microsoft.com/office/powerpoint/2012/main" userId="S-1-5-21-3254867731-1151159020-865059668-1134" providerId="AD"/>
      </p:ext>
    </p:extLst>
  </p:cmAuthor>
  <p:cmAuthor id="2" name="Pierre THEUREY" initials="PT" lastIdx="12" clrIdx="1">
    <p:extLst>
      <p:ext uri="{19B8F6BF-5375-455C-9EA6-DF929625EA0E}">
        <p15:presenceInfo xmlns:p15="http://schemas.microsoft.com/office/powerpoint/2012/main" userId="S::pierre.theurey@poxel.onmicrosoft.com::e1ae7e78-8f76-409d-9ee4-817d984c7531" providerId="AD"/>
      </p:ext>
    </p:extLst>
  </p:cmAuthor>
  <p:cmAuthor id="3" name="David MOLLER" initials="DM" lastIdx="10" clrIdx="2">
    <p:extLst>
      <p:ext uri="{19B8F6BF-5375-455C-9EA6-DF929625EA0E}">
        <p15:presenceInfo xmlns:p15="http://schemas.microsoft.com/office/powerpoint/2012/main" userId="S-1-5-21-3254867731-1151159020-865059668-2304" providerId="AD"/>
      </p:ext>
    </p:extLst>
  </p:cmAuthor>
  <p:cmAuthor id="4" name="Sebastien BOLZE" initials="SB" lastIdx="7" clrIdx="3">
    <p:extLst>
      <p:ext uri="{19B8F6BF-5375-455C-9EA6-DF929625EA0E}">
        <p15:presenceInfo xmlns:p15="http://schemas.microsoft.com/office/powerpoint/2012/main" userId="S-1-5-21-3254867731-1151159020-865059668-1139" providerId="AD"/>
      </p:ext>
    </p:extLst>
  </p:cmAuthor>
  <p:cmAuthor id="5" name="Nitta, Masahiro(仁田 正弘)" initials="N正" lastIdx="4" clrIdx="4">
    <p:extLst>
      <p:ext uri="{19B8F6BF-5375-455C-9EA6-DF929625EA0E}">
        <p15:presenceInfo xmlns:p15="http://schemas.microsoft.com/office/powerpoint/2012/main" userId="S::00945055@ds-pharma.co.jp::98020302-21b0-4de8-a1fe-8a0e135500d7" providerId="AD"/>
      </p:ext>
    </p:extLst>
  </p:cmAuthor>
  <p:cmAuthor id="6" name="GUILLAUME VIAL" initials="GV" lastIdx="6" clrIdx="5">
    <p:extLst>
      <p:ext uri="{19B8F6BF-5375-455C-9EA6-DF929625EA0E}">
        <p15:presenceInfo xmlns:p15="http://schemas.microsoft.com/office/powerpoint/2012/main" userId="S-1-5-21-2901163039-3281240111-3707936290-9082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FD5EA"/>
    <a:srgbClr val="E9EB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103" autoAdjust="0"/>
    <p:restoredTop sz="94660"/>
  </p:normalViewPr>
  <p:slideViewPr>
    <p:cSldViewPr snapToGrid="0">
      <p:cViewPr>
        <p:scale>
          <a:sx n="100" d="100"/>
          <a:sy n="100" d="100"/>
        </p:scale>
        <p:origin x="2011" y="-34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TH\Desktop\Scientific%20communication\Writting\Imeg\Article%20DSP\SP001_Lactic%20acidosis%20in%20dog\Data%20dog%20from%20report%20q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3.xlsx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4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TH\Desktop\Scientific%20communication\Writting\Imeg\Article%20DSP\04CM002_ARF%20lactic%20acidosis%20prod\data\20040728_table%20PK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 b="1"/>
              <a:t>30 mg/kg</a:t>
            </a:r>
          </a:p>
        </c:rich>
      </c:tx>
      <c:layout>
        <c:manualLayout>
          <c:xMode val="edge"/>
          <c:yMode val="edge"/>
          <c:x val="0.45395673937259301"/>
          <c:y val="2.3164234422052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9475947595951923"/>
          <c:y val="0.12326912322306507"/>
          <c:w val="0.75663285122507329"/>
          <c:h val="0.7550259039460363"/>
        </c:manualLayout>
      </c:layout>
      <c:scatterChart>
        <c:scatterStyle val="lineMarker"/>
        <c:varyColors val="0"/>
        <c:ser>
          <c:idx val="0"/>
          <c:order val="0"/>
          <c:tx>
            <c:strRef>
              <c:f>PK!$B$60</c:f>
              <c:strCache>
                <c:ptCount val="1"/>
                <c:pt idx="0">
                  <c:v>Met 30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K!$C$92:$L$92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7430.0066756363012</c:v>
                  </c:pt>
                  <c:pt idx="2">
                    <c:v>8179.5366616942301</c:v>
                  </c:pt>
                  <c:pt idx="3">
                    <c:v>6722.5147675553671</c:v>
                  </c:pt>
                  <c:pt idx="4">
                    <c:v>9929.0362472900651</c:v>
                  </c:pt>
                  <c:pt idx="5">
                    <c:v>10042.181286951554</c:v>
                  </c:pt>
                  <c:pt idx="6">
                    <c:v>7547.6238512527898</c:v>
                  </c:pt>
                  <c:pt idx="7">
                    <c:v>8180.4310888852306</c:v>
                  </c:pt>
                  <c:pt idx="8">
                    <c:v>7213.1080818188211</c:v>
                  </c:pt>
                  <c:pt idx="9">
                    <c:v>5710.4704009389625</c:v>
                  </c:pt>
                </c:numCache>
              </c:numRef>
            </c:plus>
            <c:minus>
              <c:numRef>
                <c:f>PK!$C$92:$L$92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7430.0066756363012</c:v>
                  </c:pt>
                  <c:pt idx="2">
                    <c:v>8179.5366616942301</c:v>
                  </c:pt>
                  <c:pt idx="3">
                    <c:v>6722.5147675553671</c:v>
                  </c:pt>
                  <c:pt idx="4">
                    <c:v>9929.0362472900651</c:v>
                  </c:pt>
                  <c:pt idx="5">
                    <c:v>10042.181286951554</c:v>
                  </c:pt>
                  <c:pt idx="6">
                    <c:v>7547.6238512527898</c:v>
                  </c:pt>
                  <c:pt idx="7">
                    <c:v>8180.4310888852306</c:v>
                  </c:pt>
                  <c:pt idx="8">
                    <c:v>7213.1080818188211</c:v>
                  </c:pt>
                  <c:pt idx="9">
                    <c:v>5710.47040093896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0:$L$60</c:f>
              <c:numCache>
                <c:formatCode>General</c:formatCode>
                <c:ptCount val="10"/>
                <c:pt idx="0">
                  <c:v>836</c:v>
                </c:pt>
                <c:pt idx="1">
                  <c:v>31040</c:v>
                </c:pt>
                <c:pt idx="2">
                  <c:v>41920</c:v>
                </c:pt>
                <c:pt idx="3">
                  <c:v>32780</c:v>
                </c:pt>
                <c:pt idx="4">
                  <c:v>53320</c:v>
                </c:pt>
                <c:pt idx="5">
                  <c:v>61440</c:v>
                </c:pt>
                <c:pt idx="6">
                  <c:v>58660</c:v>
                </c:pt>
                <c:pt idx="7">
                  <c:v>54880</c:v>
                </c:pt>
                <c:pt idx="8">
                  <c:v>40320</c:v>
                </c:pt>
                <c:pt idx="9">
                  <c:v>3946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545-4C81-A66E-F981B729298B}"/>
            </c:ext>
          </c:extLst>
        </c:ser>
        <c:ser>
          <c:idx val="1"/>
          <c:order val="1"/>
          <c:tx>
            <c:strRef>
              <c:f>PK!$B$61</c:f>
              <c:strCache>
                <c:ptCount val="1"/>
                <c:pt idx="0">
                  <c:v>Imeg 30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K!$C$93:$L$93</c:f>
                <c:numCache>
                  <c:formatCode>General</c:formatCode>
                  <c:ptCount val="10"/>
                  <c:pt idx="0">
                    <c:v>3.5777087639996634</c:v>
                  </c:pt>
                  <c:pt idx="1">
                    <c:v>1347.4545632413733</c:v>
                  </c:pt>
                  <c:pt idx="2">
                    <c:v>5117.4651733060182</c:v>
                  </c:pt>
                  <c:pt idx="3">
                    <c:v>5587.9338757719743</c:v>
                  </c:pt>
                  <c:pt idx="4">
                    <c:v>7053.0056146298366</c:v>
                  </c:pt>
                  <c:pt idx="5">
                    <c:v>9619.564439204094</c:v>
                  </c:pt>
                  <c:pt idx="6">
                    <c:v>7868.27599922626</c:v>
                  </c:pt>
                  <c:pt idx="7">
                    <c:v>4899.2249387020393</c:v>
                  </c:pt>
                  <c:pt idx="8">
                    <c:v>3561.161860966165</c:v>
                  </c:pt>
                  <c:pt idx="9">
                    <c:v>2650.1877669327505</c:v>
                  </c:pt>
                </c:numCache>
              </c:numRef>
            </c:plus>
            <c:minus>
              <c:numRef>
                <c:f>PK!$C$93:$L$93</c:f>
                <c:numCache>
                  <c:formatCode>General</c:formatCode>
                  <c:ptCount val="10"/>
                  <c:pt idx="0">
                    <c:v>3.5777087639996634</c:v>
                  </c:pt>
                  <c:pt idx="1">
                    <c:v>1347.4545632413733</c:v>
                  </c:pt>
                  <c:pt idx="2">
                    <c:v>5117.4651733060182</c:v>
                  </c:pt>
                  <c:pt idx="3">
                    <c:v>5587.9338757719743</c:v>
                  </c:pt>
                  <c:pt idx="4">
                    <c:v>7053.0056146298366</c:v>
                  </c:pt>
                  <c:pt idx="5">
                    <c:v>9619.564439204094</c:v>
                  </c:pt>
                  <c:pt idx="6">
                    <c:v>7868.27599922626</c:v>
                  </c:pt>
                  <c:pt idx="7">
                    <c:v>4899.2249387020393</c:v>
                  </c:pt>
                  <c:pt idx="8">
                    <c:v>3561.161860966165</c:v>
                  </c:pt>
                  <c:pt idx="9">
                    <c:v>2650.18776693275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1:$L$61</c:f>
              <c:numCache>
                <c:formatCode>General</c:formatCode>
                <c:ptCount val="10"/>
                <c:pt idx="0">
                  <c:v>118</c:v>
                </c:pt>
                <c:pt idx="1">
                  <c:v>10778</c:v>
                </c:pt>
                <c:pt idx="2">
                  <c:v>25100</c:v>
                </c:pt>
                <c:pt idx="3">
                  <c:v>30900</c:v>
                </c:pt>
                <c:pt idx="4">
                  <c:v>50580</c:v>
                </c:pt>
                <c:pt idx="5">
                  <c:v>52160</c:v>
                </c:pt>
                <c:pt idx="6">
                  <c:v>42800</c:v>
                </c:pt>
                <c:pt idx="7">
                  <c:v>35860</c:v>
                </c:pt>
                <c:pt idx="8">
                  <c:v>30180</c:v>
                </c:pt>
                <c:pt idx="9">
                  <c:v>2718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545-4C81-A66E-F981B72929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6910399"/>
        <c:axId val="1736906239"/>
      </c:scatterChart>
      <c:valAx>
        <c:axId val="1736910399"/>
        <c:scaling>
          <c:orientation val="minMax"/>
          <c:max val="2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Time (min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06239"/>
        <c:crosses val="autoZero"/>
        <c:crossBetween val="midCat"/>
      </c:valAx>
      <c:valAx>
        <c:axId val="17369062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Plasma concentration (ng/mL)</a:t>
                </a:r>
              </a:p>
            </c:rich>
          </c:tx>
          <c:layout>
            <c:manualLayout>
              <c:xMode val="edge"/>
              <c:yMode val="edge"/>
              <c:x val="0"/>
              <c:y val="0.209154350320373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1039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8721633218450855"/>
          <c:y val="0.69097235241112298"/>
          <c:w val="0.29948794968744125"/>
          <c:h val="0.105733428550328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 b="1"/>
              <a:t>300 mg/kg</a:t>
            </a:r>
          </a:p>
        </c:rich>
      </c:tx>
      <c:layout>
        <c:manualLayout>
          <c:xMode val="edge"/>
          <c:yMode val="edge"/>
          <c:x val="0.45395673937259301"/>
          <c:y val="2.3164234422052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23437978598318299"/>
          <c:y val="0.12320770085076176"/>
          <c:w val="0.71526920074698386"/>
          <c:h val="0.75588219364964859"/>
        </c:manualLayout>
      </c:layout>
      <c:scatterChart>
        <c:scatterStyle val="lineMarker"/>
        <c:varyColors val="0"/>
        <c:ser>
          <c:idx val="0"/>
          <c:order val="0"/>
          <c:tx>
            <c:strRef>
              <c:f>PK!$B$64</c:f>
              <c:strCache>
                <c:ptCount val="1"/>
                <c:pt idx="0">
                  <c:v>Met 300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K!$C$96:$L$96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76703.839832175276</c:v>
                  </c:pt>
                  <c:pt idx="2">
                    <c:v>206909.63094839253</c:v>
                  </c:pt>
                  <c:pt idx="3">
                    <c:v>113287.25358485834</c:v>
                  </c:pt>
                  <c:pt idx="4">
                    <c:v>101173.13170995547</c:v>
                  </c:pt>
                  <c:pt idx="5">
                    <c:v>113577.49520833782</c:v>
                  </c:pt>
                  <c:pt idx="6">
                    <c:v>100402.58268490905</c:v>
                  </c:pt>
                  <c:pt idx="7">
                    <c:v>114390.08231136124</c:v>
                  </c:pt>
                  <c:pt idx="8">
                    <c:v>141951.85620202366</c:v>
                  </c:pt>
                  <c:pt idx="9">
                    <c:v>149929.69953214738</c:v>
                  </c:pt>
                </c:numCache>
              </c:numRef>
            </c:plus>
            <c:minus>
              <c:numRef>
                <c:f>PK!$C$96:$L$96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76703.839832175276</c:v>
                  </c:pt>
                  <c:pt idx="2">
                    <c:v>206909.63094839253</c:v>
                  </c:pt>
                  <c:pt idx="3">
                    <c:v>113287.25358485834</c:v>
                  </c:pt>
                  <c:pt idx="4">
                    <c:v>101173.13170995547</c:v>
                  </c:pt>
                  <c:pt idx="5">
                    <c:v>113577.49520833782</c:v>
                  </c:pt>
                  <c:pt idx="6">
                    <c:v>100402.58268490905</c:v>
                  </c:pt>
                  <c:pt idx="7">
                    <c:v>114390.08231136124</c:v>
                  </c:pt>
                  <c:pt idx="8">
                    <c:v>141951.85620202366</c:v>
                  </c:pt>
                  <c:pt idx="9">
                    <c:v>149929.699532147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4:$L$64</c:f>
              <c:numCache>
                <c:formatCode>General</c:formatCode>
                <c:ptCount val="10"/>
                <c:pt idx="0">
                  <c:v>0</c:v>
                </c:pt>
                <c:pt idx="1">
                  <c:v>1008600</c:v>
                </c:pt>
                <c:pt idx="2">
                  <c:v>1294800</c:v>
                </c:pt>
                <c:pt idx="3">
                  <c:v>917800</c:v>
                </c:pt>
                <c:pt idx="4">
                  <c:v>831400</c:v>
                </c:pt>
                <c:pt idx="5">
                  <c:v>730600</c:v>
                </c:pt>
                <c:pt idx="6">
                  <c:v>697600</c:v>
                </c:pt>
                <c:pt idx="7">
                  <c:v>717800</c:v>
                </c:pt>
                <c:pt idx="8">
                  <c:v>781200</c:v>
                </c:pt>
                <c:pt idx="9">
                  <c:v>7728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80F-45F9-882C-03564158E2FC}"/>
            </c:ext>
          </c:extLst>
        </c:ser>
        <c:ser>
          <c:idx val="1"/>
          <c:order val="1"/>
          <c:tx>
            <c:strRef>
              <c:f>PK!$B$65</c:f>
              <c:strCache>
                <c:ptCount val="1"/>
                <c:pt idx="0">
                  <c:v>Imeg 300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PK!$C$97:$L$97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81183.578418298363</c:v>
                  </c:pt>
                  <c:pt idx="2">
                    <c:v>127615.97718467699</c:v>
                  </c:pt>
                  <c:pt idx="3">
                    <c:v>167904.1083624817</c:v>
                  </c:pt>
                  <c:pt idx="4">
                    <c:v>121757.47908362755</c:v>
                  </c:pt>
                  <c:pt idx="5">
                    <c:v>84202.270187923074</c:v>
                  </c:pt>
                  <c:pt idx="6">
                    <c:v>89200.329331230605</c:v>
                  </c:pt>
                  <c:pt idx="7">
                    <c:v>66755.126186683221</c:v>
                  </c:pt>
                  <c:pt idx="8">
                    <c:v>50371.456115542263</c:v>
                  </c:pt>
                  <c:pt idx="9">
                    <c:v>45816.585645375191</c:v>
                  </c:pt>
                </c:numCache>
              </c:numRef>
            </c:plus>
            <c:minus>
              <c:numRef>
                <c:f>PK!$C$97:$L$97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81183.578418298363</c:v>
                  </c:pt>
                  <c:pt idx="2">
                    <c:v>127615.97718467699</c:v>
                  </c:pt>
                  <c:pt idx="3">
                    <c:v>167904.1083624817</c:v>
                  </c:pt>
                  <c:pt idx="4">
                    <c:v>121757.47908362755</c:v>
                  </c:pt>
                  <c:pt idx="5">
                    <c:v>84202.270187923074</c:v>
                  </c:pt>
                  <c:pt idx="6">
                    <c:v>89200.329331230605</c:v>
                  </c:pt>
                  <c:pt idx="7">
                    <c:v>66755.126186683221</c:v>
                  </c:pt>
                  <c:pt idx="8">
                    <c:v>50371.456115542263</c:v>
                  </c:pt>
                  <c:pt idx="9">
                    <c:v>45816.5856453751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5:$L$65</c:f>
              <c:numCache>
                <c:formatCode>General</c:formatCode>
                <c:ptCount val="10"/>
                <c:pt idx="0">
                  <c:v>106</c:v>
                </c:pt>
                <c:pt idx="1">
                  <c:v>546200</c:v>
                </c:pt>
                <c:pt idx="2">
                  <c:v>838800</c:v>
                </c:pt>
                <c:pt idx="3">
                  <c:v>661400</c:v>
                </c:pt>
                <c:pt idx="4">
                  <c:v>488400</c:v>
                </c:pt>
                <c:pt idx="5">
                  <c:v>400000</c:v>
                </c:pt>
                <c:pt idx="6">
                  <c:v>363400</c:v>
                </c:pt>
                <c:pt idx="7">
                  <c:v>295200</c:v>
                </c:pt>
                <c:pt idx="8">
                  <c:v>261740</c:v>
                </c:pt>
                <c:pt idx="9">
                  <c:v>2430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80F-45F9-882C-03564158E2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6910399"/>
        <c:axId val="1736906239"/>
      </c:scatterChart>
      <c:valAx>
        <c:axId val="1736910399"/>
        <c:scaling>
          <c:orientation val="minMax"/>
          <c:max val="2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Time (min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06239"/>
        <c:crosses val="autoZero"/>
        <c:crossBetween val="midCat"/>
      </c:valAx>
      <c:valAx>
        <c:axId val="17369062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Plasma concentration (n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1039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7914104433160987"/>
          <c:y val="0.23683903990087005"/>
          <c:w val="0.33003387571760562"/>
          <c:h val="0.123490226048837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 b="1"/>
              <a:t>100 mg/kg</a:t>
            </a:r>
          </a:p>
        </c:rich>
      </c:tx>
      <c:layout>
        <c:manualLayout>
          <c:xMode val="edge"/>
          <c:yMode val="edge"/>
          <c:x val="0.45395673937259301"/>
          <c:y val="2.3164234422052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20841111491441969"/>
          <c:y val="0.12320770085076176"/>
          <c:w val="0.74131287074906749"/>
          <c:h val="0.72946537936975608"/>
        </c:manualLayout>
      </c:layout>
      <c:scatterChart>
        <c:scatterStyle val="lineMarker"/>
        <c:varyColors val="0"/>
        <c:ser>
          <c:idx val="0"/>
          <c:order val="0"/>
          <c:tx>
            <c:strRef>
              <c:f>PK!$B$62</c:f>
              <c:strCache>
                <c:ptCount val="1"/>
                <c:pt idx="0">
                  <c:v>Met 100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K!$C$94:$L$94</c:f>
                <c:numCache>
                  <c:formatCode>General</c:formatCode>
                  <c:ptCount val="10"/>
                  <c:pt idx="0">
                    <c:v>3.1304951684997055</c:v>
                  </c:pt>
                  <c:pt idx="1">
                    <c:v>41209.838398130123</c:v>
                  </c:pt>
                  <c:pt idx="2">
                    <c:v>29481.214642548224</c:v>
                  </c:pt>
                  <c:pt idx="3">
                    <c:v>49595.540527349833</c:v>
                  </c:pt>
                  <c:pt idx="4">
                    <c:v>50851.316303513711</c:v>
                  </c:pt>
                  <c:pt idx="5">
                    <c:v>47774.039552878501</c:v>
                  </c:pt>
                  <c:pt idx="6">
                    <c:v>37307.899777392988</c:v>
                  </c:pt>
                  <c:pt idx="7">
                    <c:v>35408.136423709169</c:v>
                  </c:pt>
                  <c:pt idx="8">
                    <c:v>52167.91312866559</c:v>
                  </c:pt>
                  <c:pt idx="9">
                    <c:v>51974.269641814106</c:v>
                  </c:pt>
                </c:numCache>
              </c:numRef>
            </c:plus>
            <c:minus>
              <c:numRef>
                <c:f>PK!$C$94:$L$94</c:f>
                <c:numCache>
                  <c:formatCode>General</c:formatCode>
                  <c:ptCount val="10"/>
                  <c:pt idx="0">
                    <c:v>3.1304951684997055</c:v>
                  </c:pt>
                  <c:pt idx="1">
                    <c:v>41209.838398130123</c:v>
                  </c:pt>
                  <c:pt idx="2">
                    <c:v>29481.214642548224</c:v>
                  </c:pt>
                  <c:pt idx="3">
                    <c:v>49595.540527349833</c:v>
                  </c:pt>
                  <c:pt idx="4">
                    <c:v>50851.316303513711</c:v>
                  </c:pt>
                  <c:pt idx="5">
                    <c:v>47774.039552878501</c:v>
                  </c:pt>
                  <c:pt idx="6">
                    <c:v>37307.899777392988</c:v>
                  </c:pt>
                  <c:pt idx="7">
                    <c:v>35408.136423709169</c:v>
                  </c:pt>
                  <c:pt idx="8">
                    <c:v>52167.91312866559</c:v>
                  </c:pt>
                  <c:pt idx="9">
                    <c:v>51974.2696418141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2:$L$62</c:f>
              <c:numCache>
                <c:formatCode>General</c:formatCode>
                <c:ptCount val="10"/>
                <c:pt idx="0">
                  <c:v>139</c:v>
                </c:pt>
                <c:pt idx="1">
                  <c:v>148400</c:v>
                </c:pt>
                <c:pt idx="2">
                  <c:v>220200</c:v>
                </c:pt>
                <c:pt idx="3">
                  <c:v>267600</c:v>
                </c:pt>
                <c:pt idx="4">
                  <c:v>280000</c:v>
                </c:pt>
                <c:pt idx="5">
                  <c:v>245400</c:v>
                </c:pt>
                <c:pt idx="6">
                  <c:v>207800</c:v>
                </c:pt>
                <c:pt idx="7">
                  <c:v>177320</c:v>
                </c:pt>
                <c:pt idx="8">
                  <c:v>171760</c:v>
                </c:pt>
                <c:pt idx="9">
                  <c:v>1679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158-49C4-85BD-7CA5FDAE8392}"/>
            </c:ext>
          </c:extLst>
        </c:ser>
        <c:ser>
          <c:idx val="1"/>
          <c:order val="1"/>
          <c:tx>
            <c:strRef>
              <c:f>PK!$B$63</c:f>
              <c:strCache>
                <c:ptCount val="1"/>
                <c:pt idx="0">
                  <c:v>Imeg 100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K!$C$95:$L$95</c:f>
                <c:numCache>
                  <c:formatCode>General</c:formatCode>
                  <c:ptCount val="10"/>
                  <c:pt idx="0">
                    <c:v>92.126000672991324</c:v>
                  </c:pt>
                  <c:pt idx="1">
                    <c:v>15040.687643854584</c:v>
                  </c:pt>
                  <c:pt idx="2">
                    <c:v>35279.33890820518</c:v>
                  </c:pt>
                  <c:pt idx="3">
                    <c:v>40335.983032523203</c:v>
                  </c:pt>
                  <c:pt idx="4">
                    <c:v>22502.446484771383</c:v>
                  </c:pt>
                  <c:pt idx="5">
                    <c:v>25240.288116422125</c:v>
                  </c:pt>
                  <c:pt idx="6">
                    <c:v>18407.758804373767</c:v>
                  </c:pt>
                  <c:pt idx="7">
                    <c:v>17595.171701350344</c:v>
                  </c:pt>
                  <c:pt idx="8">
                    <c:v>18016.894121906804</c:v>
                  </c:pt>
                  <c:pt idx="9">
                    <c:v>18184.15200662379</c:v>
                  </c:pt>
                </c:numCache>
              </c:numRef>
            </c:plus>
            <c:minus>
              <c:numRef>
                <c:f>PK!$C$95:$L$95</c:f>
                <c:numCache>
                  <c:formatCode>General</c:formatCode>
                  <c:ptCount val="10"/>
                  <c:pt idx="0">
                    <c:v>92.126000672991324</c:v>
                  </c:pt>
                  <c:pt idx="1">
                    <c:v>15040.687643854584</c:v>
                  </c:pt>
                  <c:pt idx="2">
                    <c:v>35279.33890820518</c:v>
                  </c:pt>
                  <c:pt idx="3">
                    <c:v>40335.983032523203</c:v>
                  </c:pt>
                  <c:pt idx="4">
                    <c:v>22502.446484771383</c:v>
                  </c:pt>
                  <c:pt idx="5">
                    <c:v>25240.288116422125</c:v>
                  </c:pt>
                  <c:pt idx="6">
                    <c:v>18407.758804373767</c:v>
                  </c:pt>
                  <c:pt idx="7">
                    <c:v>17595.171701350344</c:v>
                  </c:pt>
                  <c:pt idx="8">
                    <c:v>18016.894121906804</c:v>
                  </c:pt>
                  <c:pt idx="9">
                    <c:v>18184.152006623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3:$L$63</c:f>
              <c:numCache>
                <c:formatCode>General</c:formatCode>
                <c:ptCount val="10"/>
                <c:pt idx="0">
                  <c:v>245</c:v>
                </c:pt>
                <c:pt idx="1">
                  <c:v>63980</c:v>
                </c:pt>
                <c:pt idx="2">
                  <c:v>153260</c:v>
                </c:pt>
                <c:pt idx="3">
                  <c:v>184800</c:v>
                </c:pt>
                <c:pt idx="4">
                  <c:v>203400</c:v>
                </c:pt>
                <c:pt idx="5">
                  <c:v>206200</c:v>
                </c:pt>
                <c:pt idx="6">
                  <c:v>168980</c:v>
                </c:pt>
                <c:pt idx="7">
                  <c:v>138280</c:v>
                </c:pt>
                <c:pt idx="8">
                  <c:v>125360</c:v>
                </c:pt>
                <c:pt idx="9">
                  <c:v>1146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158-49C4-85BD-7CA5FDAE83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6910399"/>
        <c:axId val="1736906239"/>
      </c:scatterChart>
      <c:valAx>
        <c:axId val="1736910399"/>
        <c:scaling>
          <c:orientation val="minMax"/>
          <c:max val="2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Time (min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06239"/>
        <c:crosses val="autoZero"/>
        <c:crossBetween val="midCat"/>
      </c:valAx>
      <c:valAx>
        <c:axId val="17369062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Plasma concentration (n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1039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3747952416740756"/>
          <c:y val="0.65736059912579059"/>
          <c:w val="0.33003387571760562"/>
          <c:h val="0.120739200140861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 b="1"/>
              <a:t>1000 mg/kg</a:t>
            </a:r>
          </a:p>
        </c:rich>
      </c:tx>
      <c:layout>
        <c:manualLayout>
          <c:xMode val="edge"/>
          <c:yMode val="edge"/>
          <c:x val="0.45395673937259301"/>
          <c:y val="2.3164234422052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22488662860026426"/>
          <c:y val="0.12296262225310654"/>
          <c:w val="0.72715993799824674"/>
          <c:h val="0.73839033559625278"/>
        </c:manualLayout>
      </c:layout>
      <c:scatterChart>
        <c:scatterStyle val="lineMarker"/>
        <c:varyColors val="0"/>
        <c:ser>
          <c:idx val="0"/>
          <c:order val="0"/>
          <c:tx>
            <c:strRef>
              <c:f>PK!$B$66</c:f>
              <c:strCache>
                <c:ptCount val="1"/>
                <c:pt idx="0">
                  <c:v>Met 1000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K!$C$98:$L$98</c:f>
                <c:numCache>
                  <c:formatCode>General</c:formatCode>
                  <c:ptCount val="10"/>
                  <c:pt idx="0">
                    <c:v>4.0249223594996213</c:v>
                  </c:pt>
                  <c:pt idx="1">
                    <c:v>313909.50859411695</c:v>
                  </c:pt>
                  <c:pt idx="2">
                    <c:v>509156.25618546607</c:v>
                  </c:pt>
                  <c:pt idx="3">
                    <c:v>477538.70219721459</c:v>
                  </c:pt>
                  <c:pt idx="4">
                    <c:v>420500.63301355444</c:v>
                  </c:pt>
                  <c:pt idx="5">
                    <c:v>468005.89719553746</c:v>
                  </c:pt>
                  <c:pt idx="6">
                    <c:v>394979.94197275385</c:v>
                  </c:pt>
                  <c:pt idx="7">
                    <c:v>445097.82797964761</c:v>
                  </c:pt>
                  <c:pt idx="8">
                    <c:v>624590.5</c:v>
                  </c:pt>
                  <c:pt idx="9">
                    <c:v>281428.49891224591</c:v>
                  </c:pt>
                </c:numCache>
              </c:numRef>
            </c:plus>
            <c:minus>
              <c:numRef>
                <c:f>PK!$C$98:$L$98</c:f>
                <c:numCache>
                  <c:formatCode>General</c:formatCode>
                  <c:ptCount val="10"/>
                  <c:pt idx="0">
                    <c:v>4.0249223594996213</c:v>
                  </c:pt>
                  <c:pt idx="1">
                    <c:v>313909.50859411695</c:v>
                  </c:pt>
                  <c:pt idx="2">
                    <c:v>509156.25618546607</c:v>
                  </c:pt>
                  <c:pt idx="3">
                    <c:v>477538.70219721459</c:v>
                  </c:pt>
                  <c:pt idx="4">
                    <c:v>420500.63301355444</c:v>
                  </c:pt>
                  <c:pt idx="5">
                    <c:v>468005.89719553746</c:v>
                  </c:pt>
                  <c:pt idx="6">
                    <c:v>394979.94197275385</c:v>
                  </c:pt>
                  <c:pt idx="7">
                    <c:v>445097.82797964761</c:v>
                  </c:pt>
                  <c:pt idx="8">
                    <c:v>624590.5</c:v>
                  </c:pt>
                  <c:pt idx="9">
                    <c:v>281428.498912245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6:$L$66</c:f>
              <c:numCache>
                <c:formatCode>General</c:formatCode>
                <c:ptCount val="10"/>
                <c:pt idx="0">
                  <c:v>92</c:v>
                </c:pt>
                <c:pt idx="1">
                  <c:v>2082000</c:v>
                </c:pt>
                <c:pt idx="2">
                  <c:v>3200000</c:v>
                </c:pt>
                <c:pt idx="3">
                  <c:v>2478000</c:v>
                </c:pt>
                <c:pt idx="4">
                  <c:v>1802400</c:v>
                </c:pt>
                <c:pt idx="5">
                  <c:v>1763800</c:v>
                </c:pt>
                <c:pt idx="6">
                  <c:v>1488400</c:v>
                </c:pt>
                <c:pt idx="7">
                  <c:v>1460800</c:v>
                </c:pt>
                <c:pt idx="8">
                  <c:v>1646200</c:v>
                </c:pt>
                <c:pt idx="9">
                  <c:v>722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3EC-4600-A94A-D4C36C3CD389}"/>
            </c:ext>
          </c:extLst>
        </c:ser>
        <c:ser>
          <c:idx val="1"/>
          <c:order val="1"/>
          <c:tx>
            <c:strRef>
              <c:f>PK!$B$67</c:f>
              <c:strCache>
                <c:ptCount val="1"/>
                <c:pt idx="0">
                  <c:v>Imeg 1000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K!$C$99:$L$99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98315.97449726533</c:v>
                  </c:pt>
                  <c:pt idx="2">
                    <c:v>275738.93379100453</c:v>
                  </c:pt>
                  <c:pt idx="3">
                    <c:v>277497.37764851039</c:v>
                  </c:pt>
                  <c:pt idx="4">
                    <c:v>265269.66352035053</c:v>
                  </c:pt>
                  <c:pt idx="5">
                    <c:v>352109.15228093689</c:v>
                  </c:pt>
                  <c:pt idx="6">
                    <c:v>419518.10474424105</c:v>
                  </c:pt>
                  <c:pt idx="7">
                    <c:v>429701.15831377509</c:v>
                  </c:pt>
                  <c:pt idx="8">
                    <c:v>376601.69926568307</c:v>
                  </c:pt>
                  <c:pt idx="9">
                    <c:v>351163.74274004996</c:v>
                  </c:pt>
                </c:numCache>
              </c:numRef>
            </c:plus>
            <c:minus>
              <c:numRef>
                <c:f>PK!$C$99:$L$99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98315.97449726533</c:v>
                  </c:pt>
                  <c:pt idx="2">
                    <c:v>275738.93379100453</c:v>
                  </c:pt>
                  <c:pt idx="3">
                    <c:v>277497.37764851039</c:v>
                  </c:pt>
                  <c:pt idx="4">
                    <c:v>265269.66352035053</c:v>
                  </c:pt>
                  <c:pt idx="5">
                    <c:v>352109.15228093689</c:v>
                  </c:pt>
                  <c:pt idx="6">
                    <c:v>419518.10474424105</c:v>
                  </c:pt>
                  <c:pt idx="7">
                    <c:v>429701.15831377509</c:v>
                  </c:pt>
                  <c:pt idx="8">
                    <c:v>376601.69926568307</c:v>
                  </c:pt>
                  <c:pt idx="9">
                    <c:v>351163.742740049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K!$C$59:$L$59</c:f>
              <c:numCache>
                <c:formatCode>General</c:formatCode>
                <c:ptCount val="10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  <c:pt idx="6">
                  <c:v>150</c:v>
                </c:pt>
                <c:pt idx="7">
                  <c:v>180</c:v>
                </c:pt>
                <c:pt idx="8">
                  <c:v>210</c:v>
                </c:pt>
                <c:pt idx="9">
                  <c:v>240</c:v>
                </c:pt>
              </c:numCache>
            </c:numRef>
          </c:xVal>
          <c:yVal>
            <c:numRef>
              <c:f>PK!$C$67:$L$67</c:f>
              <c:numCache>
                <c:formatCode>General</c:formatCode>
                <c:ptCount val="10"/>
                <c:pt idx="0">
                  <c:v>296</c:v>
                </c:pt>
                <c:pt idx="1">
                  <c:v>1206600</c:v>
                </c:pt>
                <c:pt idx="2">
                  <c:v>3340000</c:v>
                </c:pt>
                <c:pt idx="3">
                  <c:v>3384000</c:v>
                </c:pt>
                <c:pt idx="4">
                  <c:v>3230000</c:v>
                </c:pt>
                <c:pt idx="5">
                  <c:v>2836000</c:v>
                </c:pt>
                <c:pt idx="6">
                  <c:v>2473200</c:v>
                </c:pt>
                <c:pt idx="7">
                  <c:v>2288000</c:v>
                </c:pt>
                <c:pt idx="8">
                  <c:v>2089800</c:v>
                </c:pt>
                <c:pt idx="9">
                  <c:v>1925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3EC-4600-A94A-D4C36C3CD3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6910399"/>
        <c:axId val="1736906239"/>
      </c:scatterChart>
      <c:valAx>
        <c:axId val="1736910399"/>
        <c:scaling>
          <c:orientation val="minMax"/>
          <c:max val="2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Time (min)</a:t>
                </a:r>
              </a:p>
            </c:rich>
          </c:tx>
          <c:layout>
            <c:manualLayout>
              <c:xMode val="edge"/>
              <c:yMode val="edge"/>
              <c:x val="0.46523105533841741"/>
              <c:y val="0.925898381962712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06239"/>
        <c:crosses val="autoZero"/>
        <c:crossBetween val="midCat"/>
      </c:valAx>
      <c:valAx>
        <c:axId val="17369062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Plasma concentration (n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691039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6487286327109143"/>
          <c:y val="0.17272567475517955"/>
          <c:w val="0.35720894275148407"/>
          <c:h val="0.106767330869478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26308471496687"/>
          <c:y val="7.534861095861288E-2"/>
          <c:w val="0.70055829061352815"/>
          <c:h val="0.68084178440866827"/>
        </c:manualLayout>
      </c:layout>
      <c:scatterChart>
        <c:scatterStyle val="lineMarker"/>
        <c:varyColors val="0"/>
        <c:ser>
          <c:idx val="0"/>
          <c:order val="0"/>
          <c:tx>
            <c:strRef>
              <c:f>'graph 9'!$J$8</c:f>
              <c:strCache>
                <c:ptCount val="1"/>
                <c:pt idx="0">
                  <c:v>Control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8:$Q$8</c:f>
                <c:numCache>
                  <c:formatCode>General</c:formatCode>
                  <c:ptCount val="6"/>
                  <c:pt idx="0">
                    <c:v>0.1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</c:v>
                  </c:pt>
                  <c:pt idx="4">
                    <c:v>0.1</c:v>
                  </c:pt>
                  <c:pt idx="5">
                    <c:v>0.1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11:$U$11</c:f>
              <c:numCache>
                <c:formatCode>General</c:formatCode>
                <c:ptCount val="5"/>
                <c:pt idx="0">
                  <c:v>1.3</c:v>
                </c:pt>
                <c:pt idx="1">
                  <c:v>1.1000000000000001</c:v>
                </c:pt>
                <c:pt idx="2">
                  <c:v>1.1000000000000001</c:v>
                </c:pt>
                <c:pt idx="3">
                  <c:v>1.1000000000000001</c:v>
                </c:pt>
                <c:pt idx="4">
                  <c:v>1.10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0B9-409E-A254-13FDD6D62F5D}"/>
            </c:ext>
          </c:extLst>
        </c:ser>
        <c:ser>
          <c:idx val="1"/>
          <c:order val="1"/>
          <c:tx>
            <c:strRef>
              <c:f>'graph 9'!$J$9</c:f>
              <c:strCache>
                <c:ptCount val="1"/>
                <c:pt idx="0">
                  <c:v>Met 25</c:v>
                </c:pt>
              </c:strCache>
            </c:strRef>
          </c:tx>
          <c:spPr>
            <a:ln w="12700">
              <a:solidFill>
                <a:schemeClr val="accent6"/>
              </a:solidFill>
              <a:prstDash val="solid"/>
            </a:ln>
          </c:spPr>
          <c:marker>
            <c:spPr>
              <a:noFill/>
              <a:ln>
                <a:solidFill>
                  <a:schemeClr val="accent6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20:$Q$20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0.3</c:v>
                  </c:pt>
                  <c:pt idx="2">
                    <c:v>0.5</c:v>
                  </c:pt>
                  <c:pt idx="3">
                    <c:v>0.3</c:v>
                  </c:pt>
                  <c:pt idx="4">
                    <c:v>0.2</c:v>
                  </c:pt>
                  <c:pt idx="5">
                    <c:v>0.5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15:$U$15</c:f>
              <c:numCache>
                <c:formatCode>General</c:formatCode>
                <c:ptCount val="5"/>
                <c:pt idx="0">
                  <c:v>2.7</c:v>
                </c:pt>
                <c:pt idx="1">
                  <c:v>2.8</c:v>
                </c:pt>
                <c:pt idx="2">
                  <c:v>3.1</c:v>
                </c:pt>
                <c:pt idx="3">
                  <c:v>3.9</c:v>
                </c:pt>
                <c:pt idx="4">
                  <c:v>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0B9-409E-A254-13FDD6D62F5D}"/>
            </c:ext>
          </c:extLst>
        </c:ser>
        <c:ser>
          <c:idx val="2"/>
          <c:order val="2"/>
          <c:tx>
            <c:strRef>
              <c:f>'graph 9'!$J$10</c:f>
              <c:strCache>
                <c:ptCount val="1"/>
                <c:pt idx="0">
                  <c:v>Met 50</c:v>
                </c:pt>
              </c:strCache>
            </c:strRef>
          </c:tx>
          <c:spPr>
            <a:ln w="12700">
              <a:solidFill>
                <a:schemeClr val="accent5"/>
              </a:solidFill>
              <a:prstDash val="solid"/>
            </a:ln>
          </c:spPr>
          <c:marker>
            <c:spPr>
              <a:noFill/>
              <a:ln>
                <a:solidFill>
                  <a:schemeClr val="accent5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24:$Q$24</c:f>
                <c:numCache>
                  <c:formatCode>General</c:formatCode>
                  <c:ptCount val="6"/>
                  <c:pt idx="0">
                    <c:v>0.1</c:v>
                  </c:pt>
                  <c:pt idx="1">
                    <c:v>0.4</c:v>
                  </c:pt>
                  <c:pt idx="2">
                    <c:v>0.6</c:v>
                  </c:pt>
                  <c:pt idx="3">
                    <c:v>0.9</c:v>
                  </c:pt>
                  <c:pt idx="4">
                    <c:v>1.1000000000000001</c:v>
                  </c:pt>
                  <c:pt idx="5">
                    <c:v>1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19:$U$19</c:f>
              <c:numCache>
                <c:formatCode>0.0</c:formatCode>
                <c:ptCount val="5"/>
                <c:pt idx="0" formatCode="General">
                  <c:v>1.8</c:v>
                </c:pt>
                <c:pt idx="1">
                  <c:v>2</c:v>
                </c:pt>
                <c:pt idx="2">
                  <c:v>2.2999999999999998</c:v>
                </c:pt>
                <c:pt idx="3">
                  <c:v>3</c:v>
                </c:pt>
                <c:pt idx="4" formatCode="General">
                  <c:v>3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0B9-409E-A254-13FDD6D62F5D}"/>
            </c:ext>
          </c:extLst>
        </c:ser>
        <c:ser>
          <c:idx val="3"/>
          <c:order val="3"/>
          <c:tx>
            <c:strRef>
              <c:f>'graph 9'!$J$11</c:f>
              <c:strCache>
                <c:ptCount val="1"/>
                <c:pt idx="0">
                  <c:v>Met 75</c:v>
                </c:pt>
              </c:strCache>
            </c:strRef>
          </c:tx>
          <c:spPr>
            <a:ln w="12700">
              <a:solidFill>
                <a:schemeClr val="accent2"/>
              </a:solidFill>
              <a:prstDash val="solid"/>
            </a:ln>
          </c:spPr>
          <c:marker>
            <c:symbol val="diamond"/>
            <c:size val="5"/>
            <c:spPr>
              <a:noFill/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28:$Q$28</c:f>
                <c:numCache>
                  <c:formatCode>General</c:formatCode>
                  <c:ptCount val="6"/>
                  <c:pt idx="0">
                    <c:v>0.4</c:v>
                  </c:pt>
                  <c:pt idx="1">
                    <c:v>0.4</c:v>
                  </c:pt>
                  <c:pt idx="2">
                    <c:v>0.7</c:v>
                  </c:pt>
                  <c:pt idx="3">
                    <c:v>0.9</c:v>
                  </c:pt>
                  <c:pt idx="4">
                    <c:v>1</c:v>
                  </c:pt>
                  <c:pt idx="5">
                    <c:v>2.6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23:$U$23</c:f>
              <c:numCache>
                <c:formatCode>General</c:formatCode>
                <c:ptCount val="5"/>
                <c:pt idx="0">
                  <c:v>2.5</c:v>
                </c:pt>
                <c:pt idx="1">
                  <c:v>3.4</c:v>
                </c:pt>
                <c:pt idx="2">
                  <c:v>4.9000000000000004</c:v>
                </c:pt>
                <c:pt idx="3">
                  <c:v>6.2</c:v>
                </c:pt>
                <c:pt idx="4">
                  <c:v>7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0B9-409E-A254-13FDD6D62F5D}"/>
            </c:ext>
          </c:extLst>
        </c:ser>
        <c:ser>
          <c:idx val="4"/>
          <c:order val="4"/>
          <c:tx>
            <c:strRef>
              <c:f>'graph 9'!$J$12</c:f>
              <c:strCache>
                <c:ptCount val="1"/>
                <c:pt idx="0">
                  <c:v>Met 100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dash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32:$Q$32</c:f>
                <c:numCache>
                  <c:formatCode>General</c:formatCode>
                  <c:ptCount val="6"/>
                  <c:pt idx="0">
                    <c:v>0.1</c:v>
                  </c:pt>
                  <c:pt idx="1">
                    <c:v>0.5</c:v>
                  </c:pt>
                  <c:pt idx="2">
                    <c:v>0.7</c:v>
                  </c:pt>
                  <c:pt idx="3">
                    <c:v>1.1000000000000001</c:v>
                  </c:pt>
                  <c:pt idx="4">
                    <c:v>1.6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27:$U$27</c:f>
              <c:numCache>
                <c:formatCode>General</c:formatCode>
                <c:ptCount val="5"/>
                <c:pt idx="0">
                  <c:v>1.9</c:v>
                </c:pt>
                <c:pt idx="1">
                  <c:v>2.9</c:v>
                </c:pt>
                <c:pt idx="2">
                  <c:v>4.5</c:v>
                </c:pt>
                <c:pt idx="3">
                  <c:v>6.2</c:v>
                </c:pt>
                <c:pt idx="4">
                  <c:v>7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0B9-409E-A254-13FDD6D62F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1384176"/>
        <c:axId val="1"/>
      </c:scatterChart>
      <c:valAx>
        <c:axId val="1071384176"/>
        <c:scaling>
          <c:orientation val="minMax"/>
          <c:max val="1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lang="ja-JP"/>
                </a:pPr>
                <a:r>
                  <a:rPr lang="fr-FR" dirty="0"/>
                  <a:t>Time (min)</a:t>
                </a:r>
              </a:p>
            </c:rich>
          </c:tx>
          <c:layout>
            <c:manualLayout>
              <c:xMode val="edge"/>
              <c:yMode val="edge"/>
              <c:x val="0.37502709236321985"/>
              <c:y val="0.8532530643462136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/>
            </a:pPr>
            <a:endParaRPr lang="fr-FR"/>
          </a:p>
        </c:txPr>
        <c:crossAx val="1"/>
        <c:crosses val="autoZero"/>
        <c:crossBetween val="midCat"/>
        <c:majorUnit val="30"/>
        <c:minorUnit val="1"/>
      </c:valAx>
      <c:valAx>
        <c:axId val="1"/>
        <c:scaling>
          <c:orientation val="minMax"/>
          <c:max val="10"/>
        </c:scaling>
        <c:delete val="0"/>
        <c:axPos val="l"/>
        <c:title>
          <c:tx>
            <c:rich>
              <a:bodyPr/>
              <a:lstStyle/>
              <a:p>
                <a:pPr>
                  <a:defRPr lang="ja-JP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fr-FR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ctate (</a:t>
                </a:r>
                <a:r>
                  <a:rPr lang="fr-FR" sz="9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mol</a:t>
                </a:r>
                <a:r>
                  <a:rPr lang="fr-FR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L)</a:t>
                </a:r>
              </a:p>
            </c:rich>
          </c:tx>
          <c:layout>
            <c:manualLayout>
              <c:xMode val="edge"/>
              <c:yMode val="edge"/>
              <c:x val="3.5603638984707565E-2"/>
              <c:y val="0.17521489472191021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/>
            </a:pPr>
            <a:endParaRPr lang="fr-FR"/>
          </a:p>
        </c:txPr>
        <c:crossAx val="1071384176"/>
        <c:crosses val="autoZero"/>
        <c:crossBetween val="midCat"/>
        <c:majorUnit val="2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18533123198979723"/>
          <c:y val="4.4437325297687548E-2"/>
          <c:w val="0.39498610664678951"/>
          <c:h val="0.29492565806701676"/>
        </c:manualLayout>
      </c:layout>
      <c:overlay val="0"/>
      <c:spPr>
        <a:solidFill>
          <a:srgbClr val="FFFFFF"/>
        </a:solidFill>
        <a:ln w="3175">
          <a:noFill/>
          <a:prstDash val="solid"/>
        </a:ln>
      </c:spPr>
      <c:txPr>
        <a:bodyPr/>
        <a:lstStyle/>
        <a:p>
          <a:pPr>
            <a:defRPr lang="ja-JP" sz="800"/>
          </a:pPr>
          <a:endParaRPr lang="fr-FR"/>
        </a:p>
      </c:tx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9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07277031547525"/>
          <c:y val="0.1302488727232364"/>
          <c:w val="0.72620683536320974"/>
          <c:h val="0.64262044269350294"/>
        </c:manualLayout>
      </c:layout>
      <c:scatterChart>
        <c:scatterStyle val="lineMarker"/>
        <c:varyColors val="0"/>
        <c:ser>
          <c:idx val="0"/>
          <c:order val="0"/>
          <c:tx>
            <c:strRef>
              <c:f>'graph 9'!$J$14</c:f>
              <c:strCache>
                <c:ptCount val="1"/>
                <c:pt idx="0">
                  <c:v>Control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8:$Q$8</c:f>
                <c:numCache>
                  <c:formatCode>General</c:formatCode>
                  <c:ptCount val="6"/>
                  <c:pt idx="0">
                    <c:v>0.1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</c:v>
                  </c:pt>
                  <c:pt idx="4">
                    <c:v>0.1</c:v>
                  </c:pt>
                  <c:pt idx="5">
                    <c:v>0.1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11:$U$11</c:f>
              <c:numCache>
                <c:formatCode>General</c:formatCode>
                <c:ptCount val="5"/>
                <c:pt idx="0">
                  <c:v>1.3</c:v>
                </c:pt>
                <c:pt idx="1">
                  <c:v>1.1000000000000001</c:v>
                </c:pt>
                <c:pt idx="2">
                  <c:v>1.1000000000000001</c:v>
                </c:pt>
                <c:pt idx="3">
                  <c:v>1.1000000000000001</c:v>
                </c:pt>
                <c:pt idx="4">
                  <c:v>1.10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D77-4B15-B848-111ED560164E}"/>
            </c:ext>
          </c:extLst>
        </c:ser>
        <c:ser>
          <c:idx val="1"/>
          <c:order val="1"/>
          <c:tx>
            <c:strRef>
              <c:f>'graph 9'!$J$15</c:f>
              <c:strCache>
                <c:ptCount val="1"/>
                <c:pt idx="0">
                  <c:v>Imeg 25</c:v>
                </c:pt>
              </c:strCache>
            </c:strRef>
          </c:tx>
          <c:spPr>
            <a:ln w="12700">
              <a:solidFill>
                <a:schemeClr val="accent6"/>
              </a:solidFill>
              <a:prstDash val="solid"/>
            </a:ln>
          </c:spPr>
          <c:marker>
            <c:spPr>
              <a:noFill/>
              <a:ln>
                <a:solidFill>
                  <a:schemeClr val="accent6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36:$Q$36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0.2</c:v>
                  </c:pt>
                  <c:pt idx="2">
                    <c:v>0.2</c:v>
                  </c:pt>
                  <c:pt idx="3">
                    <c:v>0.2</c:v>
                  </c:pt>
                  <c:pt idx="4">
                    <c:v>0.4</c:v>
                  </c:pt>
                  <c:pt idx="5">
                    <c:v>0.6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31:$U$31</c:f>
              <c:numCache>
                <c:formatCode>General</c:formatCode>
                <c:ptCount val="5"/>
                <c:pt idx="0">
                  <c:v>2.2000000000000002</c:v>
                </c:pt>
                <c:pt idx="1">
                  <c:v>1.9</c:v>
                </c:pt>
                <c:pt idx="2">
                  <c:v>1.8</c:v>
                </c:pt>
                <c:pt idx="3">
                  <c:v>2.1</c:v>
                </c:pt>
                <c:pt idx="4">
                  <c:v>2.29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D77-4B15-B848-111ED560164E}"/>
            </c:ext>
          </c:extLst>
        </c:ser>
        <c:ser>
          <c:idx val="2"/>
          <c:order val="2"/>
          <c:tx>
            <c:strRef>
              <c:f>'graph 9'!$J$16</c:f>
              <c:strCache>
                <c:ptCount val="1"/>
                <c:pt idx="0">
                  <c:v>Imeg 50</c:v>
                </c:pt>
              </c:strCache>
            </c:strRef>
          </c:tx>
          <c:spPr>
            <a:ln w="12700">
              <a:solidFill>
                <a:schemeClr val="accent5"/>
              </a:solidFill>
              <a:prstDash val="solid"/>
            </a:ln>
          </c:spPr>
          <c:marker>
            <c:spPr>
              <a:noFill/>
              <a:ln w="12700">
                <a:solidFill>
                  <a:schemeClr val="accent5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40:$Q$40</c:f>
                <c:numCache>
                  <c:formatCode>General</c:formatCode>
                  <c:ptCount val="6"/>
                  <c:pt idx="0">
                    <c:v>0.1</c:v>
                  </c:pt>
                  <c:pt idx="1">
                    <c:v>0.2</c:v>
                  </c:pt>
                  <c:pt idx="2">
                    <c:v>0.2</c:v>
                  </c:pt>
                  <c:pt idx="3">
                    <c:v>0.2</c:v>
                  </c:pt>
                  <c:pt idx="4">
                    <c:v>0.3</c:v>
                  </c:pt>
                  <c:pt idx="5">
                    <c:v>0.2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35:$U$35</c:f>
              <c:numCache>
                <c:formatCode>0.0</c:formatCode>
                <c:ptCount val="5"/>
                <c:pt idx="0" formatCode="General">
                  <c:v>1.7</c:v>
                </c:pt>
                <c:pt idx="1">
                  <c:v>1.4</c:v>
                </c:pt>
                <c:pt idx="2">
                  <c:v>1.3</c:v>
                </c:pt>
                <c:pt idx="3">
                  <c:v>1.4</c:v>
                </c:pt>
                <c:pt idx="4" formatCode="General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D77-4B15-B848-111ED560164E}"/>
            </c:ext>
          </c:extLst>
        </c:ser>
        <c:ser>
          <c:idx val="3"/>
          <c:order val="3"/>
          <c:tx>
            <c:strRef>
              <c:f>'graph 9'!$J$17</c:f>
              <c:strCache>
                <c:ptCount val="1"/>
                <c:pt idx="0">
                  <c:v>Imeg 75</c:v>
                </c:pt>
              </c:strCache>
            </c:strRef>
          </c:tx>
          <c:spPr>
            <a:ln w="12700">
              <a:solidFill>
                <a:schemeClr val="accent2"/>
              </a:solidFill>
              <a:prstDash val="solid"/>
            </a:ln>
          </c:spPr>
          <c:marker>
            <c:symbol val="diamond"/>
            <c:size val="5"/>
            <c:spPr>
              <a:noFill/>
              <a:ln w="12700">
                <a:solidFill>
                  <a:schemeClr val="accent2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44:$Q$44</c:f>
                <c:numCache>
                  <c:formatCode>General</c:formatCode>
                  <c:ptCount val="6"/>
                  <c:pt idx="0">
                    <c:v>0.3</c:v>
                  </c:pt>
                  <c:pt idx="1">
                    <c:v>0.4</c:v>
                  </c:pt>
                  <c:pt idx="2">
                    <c:v>0.5</c:v>
                  </c:pt>
                  <c:pt idx="3">
                    <c:v>0.4</c:v>
                  </c:pt>
                  <c:pt idx="4">
                    <c:v>0.5</c:v>
                  </c:pt>
                  <c:pt idx="5">
                    <c:v>0.4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39:$U$39</c:f>
              <c:numCache>
                <c:formatCode>General</c:formatCode>
                <c:ptCount val="5"/>
                <c:pt idx="0" formatCode="0.0">
                  <c:v>2</c:v>
                </c:pt>
                <c:pt idx="1">
                  <c:v>2.2999999999999998</c:v>
                </c:pt>
                <c:pt idx="2">
                  <c:v>2.2999999999999998</c:v>
                </c:pt>
                <c:pt idx="3">
                  <c:v>2.2000000000000002</c:v>
                </c:pt>
                <c:pt idx="4">
                  <c:v>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D77-4B15-B848-111ED560164E}"/>
            </c:ext>
          </c:extLst>
        </c:ser>
        <c:ser>
          <c:idx val="4"/>
          <c:order val="4"/>
          <c:tx>
            <c:strRef>
              <c:f>'graph 9'!$J$18</c:f>
              <c:strCache>
                <c:ptCount val="1"/>
                <c:pt idx="0">
                  <c:v>Imeg 100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dash"/>
            <c:size val="5"/>
            <c:spPr>
              <a:solidFill>
                <a:schemeClr val="bg1">
                  <a:lumMod val="65000"/>
                </a:schemeClr>
              </a:solidFill>
              <a:ln w="12700">
                <a:solidFill>
                  <a:srgbClr val="FF0000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2]Stat LOW glyc-Lact'!$L$48:$Q$48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0.3</c:v>
                  </c:pt>
                  <c:pt idx="2">
                    <c:v>0.3</c:v>
                  </c:pt>
                  <c:pt idx="3">
                    <c:v>0.3</c:v>
                  </c:pt>
                  <c:pt idx="4">
                    <c:v>0.6</c:v>
                  </c:pt>
                  <c:pt idx="5">
                    <c:v>0.3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graph 9'!$L$8:$L$12</c:f>
              <c:numCache>
                <c:formatCode>General</c:formatCode>
                <c:ptCount val="5"/>
                <c:pt idx="0">
                  <c:v>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</c:numCache>
            </c:numRef>
          </c:xVal>
          <c:yVal>
            <c:numRef>
              <c:f>'graph 9'!$Q$43:$U$43</c:f>
              <c:numCache>
                <c:formatCode>General</c:formatCode>
                <c:ptCount val="5"/>
                <c:pt idx="0">
                  <c:v>1.9</c:v>
                </c:pt>
                <c:pt idx="1">
                  <c:v>1.5</c:v>
                </c:pt>
                <c:pt idx="2">
                  <c:v>1.6</c:v>
                </c:pt>
                <c:pt idx="3">
                  <c:v>1.9</c:v>
                </c:pt>
                <c:pt idx="4">
                  <c:v>2.29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D77-4B15-B848-111ED56016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1366704"/>
        <c:axId val="1"/>
      </c:scatterChart>
      <c:valAx>
        <c:axId val="1071366704"/>
        <c:scaling>
          <c:orientation val="minMax"/>
          <c:max val="1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lang="ja-JP"/>
                </a:pPr>
                <a:r>
                  <a:rPr lang="fr-FR" dirty="0"/>
                  <a:t>Time</a:t>
                </a:r>
                <a:r>
                  <a:rPr lang="fr-FR" baseline="0" dirty="0"/>
                  <a:t> (min)</a:t>
                </a:r>
                <a:endParaRPr lang="fr-FR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/>
            </a:pPr>
            <a:endParaRPr lang="fr-FR"/>
          </a:p>
        </c:txPr>
        <c:crossAx val="1"/>
        <c:crosses val="autoZero"/>
        <c:crossBetween val="midCat"/>
        <c:majorUnit val="30"/>
        <c:minorUnit val="1"/>
      </c:valAx>
      <c:valAx>
        <c:axId val="1"/>
        <c:scaling>
          <c:orientation val="minMax"/>
          <c:max val="10"/>
        </c:scaling>
        <c:delete val="0"/>
        <c:axPos val="l"/>
        <c:title>
          <c:tx>
            <c:rich>
              <a:bodyPr/>
              <a:lstStyle/>
              <a:p>
                <a:pPr>
                  <a:defRPr lang="ja-JP" sz="1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fr-FR" sz="1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ctate (mmol/L)</a:t>
                </a:r>
              </a:p>
            </c:rich>
          </c:tx>
          <c:layout>
            <c:manualLayout>
              <c:xMode val="edge"/>
              <c:yMode val="edge"/>
              <c:x val="0"/>
              <c:y val="0.2085607339187690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/>
            </a:pPr>
            <a:endParaRPr lang="fr-FR"/>
          </a:p>
        </c:txPr>
        <c:crossAx val="1071366704"/>
        <c:crosses val="autoZero"/>
        <c:crossBetween val="midCat"/>
        <c:majorUnit val="2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4577949707608673"/>
          <c:y val="0.12180330192091762"/>
          <c:w val="0.33401986516391335"/>
          <c:h val="0.31574878920647065"/>
        </c:manualLayout>
      </c:layout>
      <c:overlay val="0"/>
      <c:spPr>
        <a:solidFill>
          <a:srgbClr val="FFFFFF"/>
        </a:solidFill>
        <a:ln w="3175">
          <a:noFill/>
          <a:prstDash val="solid"/>
        </a:ln>
      </c:spPr>
      <c:txPr>
        <a:bodyPr/>
        <a:lstStyle/>
        <a:p>
          <a:pPr>
            <a:defRPr lang="ja-JP" sz="800"/>
          </a:pPr>
          <a:endParaRPr lang="fr-FR"/>
        </a:p>
      </c:tx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9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b="0"/>
            </a:pPr>
            <a:r>
              <a:rPr lang="fr-FR" b="0"/>
              <a:t>Mild renal impairment</a:t>
            </a:r>
          </a:p>
        </c:rich>
      </c:tx>
      <c:layout>
        <c:manualLayout>
          <c:xMode val="edge"/>
          <c:yMode val="edge"/>
          <c:x val="0.231806326585033"/>
          <c:y val="0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7650738264130977"/>
          <c:y val="0.1715938006014342"/>
          <c:w val="0.77395770135147102"/>
          <c:h val="0.67356565814997271"/>
        </c:manualLayout>
      </c:layout>
      <c:scatterChart>
        <c:scatterStyle val="lineMarker"/>
        <c:varyColors val="0"/>
        <c:ser>
          <c:idx val="0"/>
          <c:order val="0"/>
          <c:tx>
            <c:strRef>
              <c:f>'Rat renal Tab PK Imeg'!$L$7</c:f>
              <c:strCache>
                <c:ptCount val="1"/>
                <c:pt idx="0">
                  <c:v>Imeg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at renal Tab PK Imeg'!$L$14:$L$17</c:f>
                <c:numCache>
                  <c:formatCode>General</c:formatCode>
                  <c:ptCount val="4"/>
                  <c:pt idx="0">
                    <c:v>2.4384232667397683</c:v>
                  </c:pt>
                  <c:pt idx="1">
                    <c:v>6.4445903240193978</c:v>
                  </c:pt>
                  <c:pt idx="2">
                    <c:v>18.327636008680113</c:v>
                  </c:pt>
                  <c:pt idx="3">
                    <c:v>8.2123504138418166</c:v>
                  </c:pt>
                </c:numCache>
              </c:numRef>
            </c:plus>
            <c:minus>
              <c:numRef>
                <c:f>'Rat renal Tab PK Imeg'!$L$14:$L$17</c:f>
                <c:numCache>
                  <c:formatCode>General</c:formatCode>
                  <c:ptCount val="4"/>
                  <c:pt idx="0">
                    <c:v>2.4384232667397683</c:v>
                  </c:pt>
                  <c:pt idx="1">
                    <c:v>6.4445903240193978</c:v>
                  </c:pt>
                  <c:pt idx="2">
                    <c:v>18.327636008680113</c:v>
                  </c:pt>
                  <c:pt idx="3">
                    <c:v>8.212350413841816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Rat renal Tab PK Imeg'!$K$8:$K$11</c:f>
              <c:numCache>
                <c:formatCode>General</c:formatCode>
                <c:ptCount val="4"/>
                <c:pt idx="0">
                  <c:v>75</c:v>
                </c:pt>
                <c:pt idx="1">
                  <c:v>150</c:v>
                </c:pt>
                <c:pt idx="2">
                  <c:v>225</c:v>
                </c:pt>
                <c:pt idx="3">
                  <c:v>300</c:v>
                </c:pt>
              </c:numCache>
            </c:numRef>
          </c:xVal>
          <c:yVal>
            <c:numRef>
              <c:f>'Rat renal Tab PK Imeg'!$L$8:$L$11</c:f>
              <c:numCache>
                <c:formatCode>0.00</c:formatCode>
                <c:ptCount val="4"/>
                <c:pt idx="0">
                  <c:v>53.927166666666665</c:v>
                </c:pt>
                <c:pt idx="1">
                  <c:v>98.836666666666659</c:v>
                </c:pt>
                <c:pt idx="2">
                  <c:v>182.44499999999999</c:v>
                </c:pt>
                <c:pt idx="3">
                  <c:v>220.824285714285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80E-4ABA-B369-3247089BDF12}"/>
            </c:ext>
          </c:extLst>
        </c:ser>
        <c:ser>
          <c:idx val="1"/>
          <c:order val="1"/>
          <c:tx>
            <c:strRef>
              <c:f>'Rat renal Tab PK Imeg'!$M$7</c:f>
              <c:strCache>
                <c:ptCount val="1"/>
                <c:pt idx="0">
                  <c:v>Met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at renal Tab PK Imeg'!$M$14:$M$17</c:f>
                <c:numCache>
                  <c:formatCode>General</c:formatCode>
                  <c:ptCount val="4"/>
                  <c:pt idx="0">
                    <c:v>18.075000000000014</c:v>
                  </c:pt>
                  <c:pt idx="1">
                    <c:v>5.2350198980838032</c:v>
                  </c:pt>
                  <c:pt idx="2">
                    <c:v>32.477562169049015</c:v>
                  </c:pt>
                  <c:pt idx="3">
                    <c:v>30.309999999999896</c:v>
                  </c:pt>
                </c:numCache>
              </c:numRef>
            </c:plus>
            <c:minus>
              <c:numRef>
                <c:f>'Rat renal Tab PK Imeg'!$M$14:$M$17</c:f>
                <c:numCache>
                  <c:formatCode>General</c:formatCode>
                  <c:ptCount val="4"/>
                  <c:pt idx="0">
                    <c:v>18.075000000000014</c:v>
                  </c:pt>
                  <c:pt idx="1">
                    <c:v>5.2350198980838032</c:v>
                  </c:pt>
                  <c:pt idx="2">
                    <c:v>32.477562169049015</c:v>
                  </c:pt>
                  <c:pt idx="3">
                    <c:v>30.30999999999989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Rat renal Tab PK Imeg'!$K$8:$K$11</c:f>
              <c:numCache>
                <c:formatCode>General</c:formatCode>
                <c:ptCount val="4"/>
                <c:pt idx="0">
                  <c:v>75</c:v>
                </c:pt>
                <c:pt idx="1">
                  <c:v>150</c:v>
                </c:pt>
                <c:pt idx="2">
                  <c:v>225</c:v>
                </c:pt>
                <c:pt idx="3">
                  <c:v>300</c:v>
                </c:pt>
              </c:numCache>
            </c:numRef>
          </c:xVal>
          <c:yVal>
            <c:numRef>
              <c:f>'Rat renal Tab PK Imeg'!$M$8:$M$11</c:f>
              <c:numCache>
                <c:formatCode>0.00</c:formatCode>
                <c:ptCount val="4"/>
                <c:pt idx="0">
                  <c:v>67.194999999999993</c:v>
                </c:pt>
                <c:pt idx="1">
                  <c:v>60.860000000000007</c:v>
                </c:pt>
                <c:pt idx="2">
                  <c:v>169.92333333333332</c:v>
                </c:pt>
                <c:pt idx="3">
                  <c:v>197.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80E-4ABA-B369-3247089BDF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451039"/>
        <c:axId val="1"/>
      </c:scatterChart>
      <c:valAx>
        <c:axId val="1949451039"/>
        <c:scaling>
          <c:orientation val="minMax"/>
          <c:max val="300"/>
          <c:min val="75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b="0"/>
                </a:pPr>
                <a:r>
                  <a:rPr lang="fr-FR" b="0"/>
                  <a:t>Total dose administered (mg/kg)</a:t>
                </a:r>
              </a:p>
            </c:rich>
          </c:tx>
          <c:layout>
            <c:manualLayout>
              <c:xMode val="edge"/>
              <c:yMode val="edge"/>
              <c:x val="0.30721298189045548"/>
              <c:y val="0.92619965122318393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1"/>
        <c:crosses val="autoZero"/>
        <c:crossBetween val="midCat"/>
        <c:majorUnit val="75"/>
      </c:valAx>
      <c:valAx>
        <c:axId val="1"/>
        <c:scaling>
          <c:orientation val="minMax"/>
          <c:max val="2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fr-FR" b="0"/>
                  <a:t>plasma concentration ( µg/ml)</a:t>
                </a:r>
              </a:p>
            </c:rich>
          </c:tx>
          <c:layout>
            <c:manualLayout>
              <c:xMode val="edge"/>
              <c:yMode val="edge"/>
              <c:x val="2.1432237412520195E-2"/>
              <c:y val="0.17159361818482258"/>
            </c:manualLayout>
          </c:layout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fr-FR"/>
          </a:p>
        </c:txPr>
        <c:crossAx val="1949451039"/>
        <c:crosses val="autoZero"/>
        <c:crossBetween val="midCat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26951754219666857"/>
          <c:y val="0.27132506730034978"/>
          <c:w val="0.32796704343408689"/>
          <c:h val="8.2982484332315587E-2"/>
        </c:manualLayout>
      </c:layout>
      <c:overlay val="0"/>
      <c:spPr>
        <a:noFill/>
        <a:ln w="25400">
          <a:noFill/>
        </a:ln>
      </c:spPr>
      <c:txPr>
        <a:bodyPr rot="0" vert="horz"/>
        <a:lstStyle/>
        <a:p>
          <a:pPr>
            <a:defRPr/>
          </a:pPr>
          <a:endParaRPr lang="fr-F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b="0"/>
            </a:pPr>
            <a:r>
              <a:rPr lang="fr-FR" b="0"/>
              <a:t>Severe renal impairment</a:t>
            </a:r>
          </a:p>
        </c:rich>
      </c:tx>
      <c:layout>
        <c:manualLayout>
          <c:xMode val="edge"/>
          <c:yMode val="edge"/>
          <c:x val="0.2512282222881686"/>
          <c:y val="1.9400583086816081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7650738264130977"/>
          <c:y val="0.1715938006014342"/>
          <c:w val="0.77395770135147102"/>
          <c:h val="0.63821946699845922"/>
        </c:manualLayout>
      </c:layout>
      <c:scatterChart>
        <c:scatterStyle val="lineMarker"/>
        <c:varyColors val="0"/>
        <c:ser>
          <c:idx val="0"/>
          <c:order val="0"/>
          <c:tx>
            <c:strRef>
              <c:f>'Rat renal Tab PK Imeg'!$P$7</c:f>
              <c:strCache>
                <c:ptCount val="1"/>
                <c:pt idx="0">
                  <c:v>Imeg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at renal Tab PK Imeg'!$P$14:$P$17</c:f>
                <c:numCache>
                  <c:formatCode>General</c:formatCode>
                  <c:ptCount val="4"/>
                  <c:pt idx="0">
                    <c:v>6.7681144284554531</c:v>
                  </c:pt>
                  <c:pt idx="1">
                    <c:v>11.921043281385529</c:v>
                  </c:pt>
                  <c:pt idx="2">
                    <c:v>14.447879121556568</c:v>
                  </c:pt>
                  <c:pt idx="3">
                    <c:v>5.7573966917927955</c:v>
                  </c:pt>
                </c:numCache>
              </c:numRef>
            </c:plus>
            <c:minus>
              <c:numRef>
                <c:f>'Rat renal Tab PK Imeg'!$P$14:$P$17</c:f>
                <c:numCache>
                  <c:formatCode>General</c:formatCode>
                  <c:ptCount val="4"/>
                  <c:pt idx="0">
                    <c:v>6.7681144284554531</c:v>
                  </c:pt>
                  <c:pt idx="1">
                    <c:v>11.921043281385529</c:v>
                  </c:pt>
                  <c:pt idx="2">
                    <c:v>14.447879121556568</c:v>
                  </c:pt>
                  <c:pt idx="3">
                    <c:v>5.757396691792795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Rat renal Tab PK Imeg'!$K$8:$K$11</c:f>
              <c:numCache>
                <c:formatCode>General</c:formatCode>
                <c:ptCount val="4"/>
                <c:pt idx="0">
                  <c:v>75</c:v>
                </c:pt>
                <c:pt idx="1">
                  <c:v>150</c:v>
                </c:pt>
                <c:pt idx="2">
                  <c:v>225</c:v>
                </c:pt>
                <c:pt idx="3">
                  <c:v>300</c:v>
                </c:pt>
              </c:numCache>
            </c:numRef>
          </c:xVal>
          <c:yVal>
            <c:numRef>
              <c:f>'Rat renal Tab PK Imeg'!$P$8:$P$11</c:f>
              <c:numCache>
                <c:formatCode>0.00</c:formatCode>
                <c:ptCount val="4"/>
                <c:pt idx="0">
                  <c:v>68.522499999999994</c:v>
                </c:pt>
                <c:pt idx="1">
                  <c:v>137.21250000000001</c:v>
                </c:pt>
                <c:pt idx="2">
                  <c:v>216.4666666666667</c:v>
                </c:pt>
                <c:pt idx="3">
                  <c:v>265.27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033-4947-B162-148477C6115E}"/>
            </c:ext>
          </c:extLst>
        </c:ser>
        <c:ser>
          <c:idx val="1"/>
          <c:order val="1"/>
          <c:tx>
            <c:strRef>
              <c:f>'Rat renal Tab PK Imeg'!$Q$7</c:f>
              <c:strCache>
                <c:ptCount val="1"/>
                <c:pt idx="0">
                  <c:v>Met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at renal Tab PK Imeg'!$Q$14:$Q$17</c:f>
                <c:numCache>
                  <c:formatCode>General</c:formatCode>
                  <c:ptCount val="4"/>
                  <c:pt idx="0">
                    <c:v>3.4231999324868134</c:v>
                  </c:pt>
                  <c:pt idx="1">
                    <c:v>9.6132018310469309</c:v>
                  </c:pt>
                  <c:pt idx="2">
                    <c:v>16.058668674063057</c:v>
                  </c:pt>
                  <c:pt idx="3">
                    <c:v>22.500000000000011</c:v>
                  </c:pt>
                </c:numCache>
              </c:numRef>
            </c:plus>
            <c:minus>
              <c:numRef>
                <c:f>'Rat renal Tab PK Imeg'!$Q$14:$Q$17</c:f>
                <c:numCache>
                  <c:formatCode>General</c:formatCode>
                  <c:ptCount val="4"/>
                  <c:pt idx="0">
                    <c:v>3.4231999324868134</c:v>
                  </c:pt>
                  <c:pt idx="1">
                    <c:v>9.6132018310469309</c:v>
                  </c:pt>
                  <c:pt idx="2">
                    <c:v>16.058668674063057</c:v>
                  </c:pt>
                  <c:pt idx="3">
                    <c:v>22.50000000000001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Rat renal Tab PK Imeg'!$K$8:$K$11</c:f>
              <c:numCache>
                <c:formatCode>General</c:formatCode>
                <c:ptCount val="4"/>
                <c:pt idx="0">
                  <c:v>75</c:v>
                </c:pt>
                <c:pt idx="1">
                  <c:v>150</c:v>
                </c:pt>
                <c:pt idx="2">
                  <c:v>225</c:v>
                </c:pt>
                <c:pt idx="3">
                  <c:v>300</c:v>
                </c:pt>
              </c:numCache>
            </c:numRef>
          </c:xVal>
          <c:yVal>
            <c:numRef>
              <c:f>'Rat renal Tab PK Imeg'!$Q$8:$Q$11</c:f>
              <c:numCache>
                <c:formatCode>0.00</c:formatCode>
                <c:ptCount val="4"/>
                <c:pt idx="0">
                  <c:v>56.733333333333327</c:v>
                </c:pt>
                <c:pt idx="1">
                  <c:v>136.09166666666667</c:v>
                </c:pt>
                <c:pt idx="2">
                  <c:v>171.2475</c:v>
                </c:pt>
                <c:pt idx="3">
                  <c:v>248.35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33-4947-B162-148477C611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452287"/>
        <c:axId val="1"/>
      </c:scatterChart>
      <c:valAx>
        <c:axId val="1949452287"/>
        <c:scaling>
          <c:orientation val="minMax"/>
          <c:max val="300"/>
          <c:min val="75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b="0"/>
                </a:pPr>
                <a:r>
                  <a:rPr lang="fr-FR" b="0" dirty="0"/>
                  <a:t>Total dose </a:t>
                </a:r>
                <a:r>
                  <a:rPr lang="fr-FR" b="0" dirty="0" err="1"/>
                  <a:t>administered</a:t>
                </a:r>
                <a:r>
                  <a:rPr lang="fr-FR" b="0" dirty="0"/>
                  <a:t> (mg/kg)</a:t>
                </a:r>
              </a:p>
            </c:rich>
          </c:tx>
          <c:layout>
            <c:manualLayout>
              <c:xMode val="edge"/>
              <c:yMode val="edge"/>
              <c:x val="0.32224909778866817"/>
              <c:y val="0.88993866314059078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1"/>
        <c:crosses val="autoZero"/>
        <c:crossBetween val="midCat"/>
        <c:majorUnit val="75"/>
      </c:val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fr-FR" b="0"/>
                  <a:t>plasma concentration ( µg/ml)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fr-FR"/>
          </a:p>
        </c:txPr>
        <c:crossAx val="1949452287"/>
        <c:crosses val="autoZero"/>
        <c:crossBetween val="midCat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24277736277569961"/>
          <c:y val="0.2945152764529842"/>
          <c:w val="0.3305127352038742"/>
          <c:h val="7.8017228224378954E-2"/>
        </c:manualLayout>
      </c:layout>
      <c:overlay val="0"/>
      <c:spPr>
        <a:noFill/>
        <a:ln w="25400">
          <a:noFill/>
        </a:ln>
      </c:spPr>
      <c:txPr>
        <a:bodyPr rot="0" vert="horz"/>
        <a:lstStyle/>
        <a:p>
          <a:pPr>
            <a:defRPr/>
          </a:pPr>
          <a:endParaRPr lang="fr-F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4724</cdr:x>
      <cdr:y>0.58391</cdr:y>
    </cdr:from>
    <cdr:to>
      <cdr:x>0.14724</cdr:x>
      <cdr:y>0.58391</cdr:y>
    </cdr:to>
    <cdr:sp macro="" textlink="">
      <cdr:nvSpPr>
        <cdr:cNvPr id="29697" name="Text Box 1">
          <a:extLst xmlns:a="http://schemas.openxmlformats.org/drawingml/2006/main">
            <a:ext uri="{FF2B5EF4-FFF2-40B4-BE49-F238E27FC236}">
              <a16:creationId xmlns:a16="http://schemas.microsoft.com/office/drawing/2014/main" id="{6A1E01DD-D39B-4960-BD0B-A4DDC38E49E2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666134" y="1625945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27432" tIns="27432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*</a:t>
          </a:r>
        </a:p>
      </cdr:txBody>
    </cdr:sp>
  </cdr:relSizeAnchor>
  <cdr:relSizeAnchor xmlns:cdr="http://schemas.openxmlformats.org/drawingml/2006/chartDrawing">
    <cdr:from>
      <cdr:x>0.17629</cdr:x>
      <cdr:y>0.59834</cdr:y>
    </cdr:from>
    <cdr:to>
      <cdr:x>0.17629</cdr:x>
      <cdr:y>0.59834</cdr:y>
    </cdr:to>
    <cdr:sp macro="" textlink="">
      <cdr:nvSpPr>
        <cdr:cNvPr id="29698" name="Text Box 2">
          <a:extLst xmlns:a="http://schemas.openxmlformats.org/drawingml/2006/main">
            <a:ext uri="{FF2B5EF4-FFF2-40B4-BE49-F238E27FC236}">
              <a16:creationId xmlns:a16="http://schemas.microsoft.com/office/drawing/2014/main" id="{EA50DB13-2959-47F8-8569-C2FB07E7FB8F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798071" y="1666179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36576" tIns="27432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*</a:t>
          </a:r>
        </a:p>
      </cdr:txBody>
    </cdr:sp>
  </cdr:relSizeAnchor>
  <cdr:relSizeAnchor xmlns:cdr="http://schemas.openxmlformats.org/drawingml/2006/chartDrawing">
    <cdr:from>
      <cdr:x>0.24269</cdr:x>
      <cdr:y>0.58391</cdr:y>
    </cdr:from>
    <cdr:to>
      <cdr:x>0.24269</cdr:x>
      <cdr:y>0.58391</cdr:y>
    </cdr:to>
    <cdr:sp macro="" textlink="">
      <cdr:nvSpPr>
        <cdr:cNvPr id="29699" name="Text Box 3">
          <a:extLst xmlns:a="http://schemas.openxmlformats.org/drawingml/2006/main">
            <a:ext uri="{FF2B5EF4-FFF2-40B4-BE49-F238E27FC236}">
              <a16:creationId xmlns:a16="http://schemas.microsoft.com/office/drawing/2014/main" id="{240DC519-B594-44F3-8370-217E5E3DC5AB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099640" y="1625945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27432" tIns="27432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</a:t>
          </a:r>
        </a:p>
      </cdr:txBody>
    </cdr:sp>
  </cdr:relSizeAnchor>
  <cdr:relSizeAnchor xmlns:cdr="http://schemas.openxmlformats.org/drawingml/2006/chartDrawing">
    <cdr:from>
      <cdr:x>0.26857</cdr:x>
      <cdr:y>0.53991</cdr:y>
    </cdr:from>
    <cdr:to>
      <cdr:x>0.26857</cdr:x>
      <cdr:y>0.53991</cdr:y>
    </cdr:to>
    <cdr:sp macro="" textlink="">
      <cdr:nvSpPr>
        <cdr:cNvPr id="29700" name="Text Box 4">
          <a:extLst xmlns:a="http://schemas.openxmlformats.org/drawingml/2006/main">
            <a:ext uri="{FF2B5EF4-FFF2-40B4-BE49-F238E27FC236}">
              <a16:creationId xmlns:a16="http://schemas.microsoft.com/office/drawing/2014/main" id="{E00A9D9A-3BD5-4363-9D03-78835F82329E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217163" y="1503233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36576" tIns="27432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*</a:t>
          </a:r>
        </a:p>
      </cdr:txBody>
    </cdr:sp>
  </cdr:relSizeAnchor>
  <cdr:relSizeAnchor xmlns:cdr="http://schemas.openxmlformats.org/drawingml/2006/chartDrawing">
    <cdr:from>
      <cdr:x>0.29127</cdr:x>
      <cdr:y>0.56708</cdr:y>
    </cdr:from>
    <cdr:to>
      <cdr:x>0.29127</cdr:x>
      <cdr:y>0.56708</cdr:y>
    </cdr:to>
    <cdr:sp macro="" textlink="">
      <cdr:nvSpPr>
        <cdr:cNvPr id="29701" name="Text Box 5">
          <a:extLst xmlns:a="http://schemas.openxmlformats.org/drawingml/2006/main">
            <a:ext uri="{FF2B5EF4-FFF2-40B4-BE49-F238E27FC236}">
              <a16:creationId xmlns:a16="http://schemas.microsoft.com/office/drawing/2014/main" id="{35F3A835-EC0F-4C26-83C6-CF5A8571E3C8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320273" y="1579006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27432" tIns="27432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</a:t>
          </a:r>
        </a:p>
      </cdr:txBody>
    </cdr:sp>
  </cdr:relSizeAnchor>
  <cdr:relSizeAnchor xmlns:cdr="http://schemas.openxmlformats.org/drawingml/2006/chartDrawing">
    <cdr:from>
      <cdr:x>0.44336</cdr:x>
      <cdr:y>0.4096</cdr:y>
    </cdr:from>
    <cdr:to>
      <cdr:x>0.44336</cdr:x>
      <cdr:y>0.4096</cdr:y>
    </cdr:to>
    <cdr:sp macro="" textlink="">
      <cdr:nvSpPr>
        <cdr:cNvPr id="29702" name="Text Box 6">
          <a:extLst xmlns:a="http://schemas.openxmlformats.org/drawingml/2006/main">
            <a:ext uri="{FF2B5EF4-FFF2-40B4-BE49-F238E27FC236}">
              <a16:creationId xmlns:a16="http://schemas.microsoft.com/office/drawing/2014/main" id="{93DA184E-CE3D-49AB-8E55-47DAA7869AF8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010999" y="1139789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36576" tIns="27432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*</a:t>
          </a:r>
        </a:p>
      </cdr:txBody>
    </cdr:sp>
  </cdr:relSizeAnchor>
  <cdr:relSizeAnchor xmlns:cdr="http://schemas.openxmlformats.org/drawingml/2006/chartDrawing">
    <cdr:from>
      <cdr:x>0.47901</cdr:x>
      <cdr:y>0.4096</cdr:y>
    </cdr:from>
    <cdr:to>
      <cdr:x>0.47901</cdr:x>
      <cdr:y>0.4096</cdr:y>
    </cdr:to>
    <cdr:sp macro="" textlink="">
      <cdr:nvSpPr>
        <cdr:cNvPr id="29703" name="Text Box 7">
          <a:extLst xmlns:a="http://schemas.openxmlformats.org/drawingml/2006/main">
            <a:ext uri="{FF2B5EF4-FFF2-40B4-BE49-F238E27FC236}">
              <a16:creationId xmlns:a16="http://schemas.microsoft.com/office/drawing/2014/main" id="{FBBC7CDB-F88E-420A-907B-35E9FC06A3C6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172871" y="1139789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36576" tIns="27432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*</a:t>
          </a:r>
        </a:p>
      </cdr:txBody>
    </cdr:sp>
  </cdr:relSizeAnchor>
  <cdr:relSizeAnchor xmlns:cdr="http://schemas.openxmlformats.org/drawingml/2006/chartDrawing">
    <cdr:from>
      <cdr:x>0.51758</cdr:x>
      <cdr:y>0.50168</cdr:y>
    </cdr:from>
    <cdr:to>
      <cdr:x>0.51758</cdr:x>
      <cdr:y>0.50168</cdr:y>
    </cdr:to>
    <cdr:sp macro="" textlink="">
      <cdr:nvSpPr>
        <cdr:cNvPr id="29704" name="Text Box 8">
          <a:extLst xmlns:a="http://schemas.openxmlformats.org/drawingml/2006/main">
            <a:ext uri="{FF2B5EF4-FFF2-40B4-BE49-F238E27FC236}">
              <a16:creationId xmlns:a16="http://schemas.microsoft.com/office/drawing/2014/main" id="{5A689203-CD98-412B-A4FC-DF71D01BE466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348047" y="1396614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27432" tIns="27432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</a:t>
          </a:r>
        </a:p>
      </cdr:txBody>
    </cdr:sp>
  </cdr:relSizeAnchor>
  <cdr:relSizeAnchor xmlns:cdr="http://schemas.openxmlformats.org/drawingml/2006/chartDrawing">
    <cdr:from>
      <cdr:x>0.54028</cdr:x>
      <cdr:y>0.36896</cdr:y>
    </cdr:from>
    <cdr:to>
      <cdr:x>0.54028</cdr:x>
      <cdr:y>0.36896</cdr:y>
    </cdr:to>
    <cdr:sp macro="" textlink="">
      <cdr:nvSpPr>
        <cdr:cNvPr id="29705" name="Text Box 9">
          <a:extLst xmlns:a="http://schemas.openxmlformats.org/drawingml/2006/main">
            <a:ext uri="{FF2B5EF4-FFF2-40B4-BE49-F238E27FC236}">
              <a16:creationId xmlns:a16="http://schemas.microsoft.com/office/drawing/2014/main" id="{A8701DFE-CAAC-4255-AC2A-C259D06ECC47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451157" y="1026465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36576" tIns="27432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*</a:t>
          </a:r>
        </a:p>
      </cdr:txBody>
    </cdr:sp>
  </cdr:relSizeAnchor>
  <cdr:relSizeAnchor xmlns:cdr="http://schemas.openxmlformats.org/drawingml/2006/chartDrawing">
    <cdr:from>
      <cdr:x>0.56811</cdr:x>
      <cdr:y>0.32496</cdr:y>
    </cdr:from>
    <cdr:to>
      <cdr:x>0.56811</cdr:x>
      <cdr:y>0.32496</cdr:y>
    </cdr:to>
    <cdr:sp macro="" textlink="">
      <cdr:nvSpPr>
        <cdr:cNvPr id="29706" name="Text Box 10">
          <a:extLst xmlns:a="http://schemas.openxmlformats.org/drawingml/2006/main">
            <a:ext uri="{FF2B5EF4-FFF2-40B4-BE49-F238E27FC236}">
              <a16:creationId xmlns:a16="http://schemas.microsoft.com/office/drawing/2014/main" id="{025ECCDD-7744-4F3E-B9D7-C7C3927CDA57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577550" y="903752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27432" tIns="27432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1125" b="1" i="0" u="none" strike="noStrike" baseline="0">
              <a:solidFill>
                <a:srgbClr val="000000"/>
              </a:solidFill>
              <a:latin typeface="Arial"/>
              <a:cs typeface="Arial"/>
            </a:rPr>
            <a:t>**</a:t>
          </a:r>
        </a:p>
      </cdr:txBody>
    </cdr:sp>
  </cdr:relSizeAnchor>
  <cdr:relSizeAnchor xmlns:cdr="http://schemas.openxmlformats.org/drawingml/2006/chartDrawing">
    <cdr:from>
      <cdr:x>0.36915</cdr:x>
      <cdr:y>0.45408</cdr:y>
    </cdr:from>
    <cdr:to>
      <cdr:x>0.36915</cdr:x>
      <cdr:y>0.45408</cdr:y>
    </cdr:to>
    <cdr:sp macro="" textlink="">
      <cdr:nvSpPr>
        <cdr:cNvPr id="29707" name="Text Box 11">
          <a:extLst xmlns:a="http://schemas.openxmlformats.org/drawingml/2006/main">
            <a:ext uri="{FF2B5EF4-FFF2-40B4-BE49-F238E27FC236}">
              <a16:creationId xmlns:a16="http://schemas.microsoft.com/office/drawing/2014/main" id="{5C9E6BB9-2D69-4158-83C1-754E246804AC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673951" y="1263843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42627</cdr:x>
      <cdr:y>0.51899</cdr:y>
    </cdr:from>
    <cdr:to>
      <cdr:x>0.42627</cdr:x>
      <cdr:y>0.51899</cdr:y>
    </cdr:to>
    <cdr:sp macro="" textlink="">
      <cdr:nvSpPr>
        <cdr:cNvPr id="29708" name="Text Box 12">
          <a:extLst xmlns:a="http://schemas.openxmlformats.org/drawingml/2006/main">
            <a:ext uri="{FF2B5EF4-FFF2-40B4-BE49-F238E27FC236}">
              <a16:creationId xmlns:a16="http://schemas.microsoft.com/office/drawing/2014/main" id="{888DBD37-B499-4352-9DA6-7A8C273902ED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933390" y="1444894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62206</cdr:x>
      <cdr:y>0.39974</cdr:y>
    </cdr:from>
    <cdr:to>
      <cdr:x>0.62206</cdr:x>
      <cdr:y>0.39974</cdr:y>
    </cdr:to>
    <cdr:sp macro="" textlink="">
      <cdr:nvSpPr>
        <cdr:cNvPr id="29709" name="Text Box 13">
          <a:extLst xmlns:a="http://schemas.openxmlformats.org/drawingml/2006/main">
            <a:ext uri="{FF2B5EF4-FFF2-40B4-BE49-F238E27FC236}">
              <a16:creationId xmlns:a16="http://schemas.microsoft.com/office/drawing/2014/main" id="{AB16C8C1-AF93-40C6-B26D-26177F62A560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822575" y="1112296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27432" tIns="22860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$</a:t>
          </a:r>
        </a:p>
      </cdr:txBody>
    </cdr:sp>
  </cdr:relSizeAnchor>
  <cdr:relSizeAnchor xmlns:cdr="http://schemas.openxmlformats.org/drawingml/2006/chartDrawing">
    <cdr:from>
      <cdr:x>0.51758</cdr:x>
      <cdr:y>0.4233</cdr:y>
    </cdr:from>
    <cdr:to>
      <cdr:x>0.51758</cdr:x>
      <cdr:y>0.4233</cdr:y>
    </cdr:to>
    <cdr:sp macro="" textlink="">
      <cdr:nvSpPr>
        <cdr:cNvPr id="29710" name="Text Box 14">
          <a:extLst xmlns:a="http://schemas.openxmlformats.org/drawingml/2006/main">
            <a:ext uri="{FF2B5EF4-FFF2-40B4-BE49-F238E27FC236}">
              <a16:creationId xmlns:a16="http://schemas.microsoft.com/office/drawing/2014/main" id="{FE530838-FA97-4A69-9975-9834F8520090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348047" y="1178011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27432" tIns="22860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$</a:t>
          </a:r>
        </a:p>
      </cdr:txBody>
    </cdr:sp>
  </cdr:relSizeAnchor>
  <cdr:relSizeAnchor xmlns:cdr="http://schemas.openxmlformats.org/drawingml/2006/chartDrawing">
    <cdr:from>
      <cdr:x>0.44849</cdr:x>
      <cdr:y>0.36896</cdr:y>
    </cdr:from>
    <cdr:to>
      <cdr:x>0.44849</cdr:x>
      <cdr:y>0.36896</cdr:y>
    </cdr:to>
    <cdr:sp macro="" textlink="">
      <cdr:nvSpPr>
        <cdr:cNvPr id="29711" name="Text Box 15">
          <a:extLst xmlns:a="http://schemas.openxmlformats.org/drawingml/2006/main">
            <a:ext uri="{FF2B5EF4-FFF2-40B4-BE49-F238E27FC236}">
              <a16:creationId xmlns:a16="http://schemas.microsoft.com/office/drawing/2014/main" id="{4364A39F-D2A2-417D-9E73-EDC561E574CB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034282" y="1026465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29811</cdr:x>
      <cdr:y>0.51899</cdr:y>
    </cdr:from>
    <cdr:to>
      <cdr:x>0.29811</cdr:x>
      <cdr:y>0.51899</cdr:y>
    </cdr:to>
    <cdr:sp macro="" textlink="">
      <cdr:nvSpPr>
        <cdr:cNvPr id="29712" name="Text Box 16">
          <a:extLst xmlns:a="http://schemas.openxmlformats.org/drawingml/2006/main">
            <a:ext uri="{FF2B5EF4-FFF2-40B4-BE49-F238E27FC236}">
              <a16:creationId xmlns:a16="http://schemas.microsoft.com/office/drawing/2014/main" id="{6023AFBE-3C7D-4DAB-81C1-F336A8612FC4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351317" y="1444894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5437</cdr:x>
      <cdr:y>0.32496</cdr:y>
    </cdr:from>
    <cdr:to>
      <cdr:x>0.5437</cdr:x>
      <cdr:y>0.32496</cdr:y>
    </cdr:to>
    <cdr:sp macro="" textlink="">
      <cdr:nvSpPr>
        <cdr:cNvPr id="29713" name="Text Box 17">
          <a:extLst xmlns:a="http://schemas.openxmlformats.org/drawingml/2006/main">
            <a:ext uri="{FF2B5EF4-FFF2-40B4-BE49-F238E27FC236}">
              <a16:creationId xmlns:a16="http://schemas.microsoft.com/office/drawing/2014/main" id="{9892BB49-D39E-4AC6-AD32-6D35F4E1859B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466679" y="903752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27432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975" b="0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38428</cdr:x>
      <cdr:y>0.41993</cdr:y>
    </cdr:from>
    <cdr:to>
      <cdr:x>0.38428</cdr:x>
      <cdr:y>0.41993</cdr:y>
    </cdr:to>
    <cdr:sp macro="" textlink="">
      <cdr:nvSpPr>
        <cdr:cNvPr id="29714" name="Text Box 18">
          <a:extLst xmlns:a="http://schemas.openxmlformats.org/drawingml/2006/main">
            <a:ext uri="{FF2B5EF4-FFF2-40B4-BE49-F238E27FC236}">
              <a16:creationId xmlns:a16="http://schemas.microsoft.com/office/drawing/2014/main" id="{DE8B90BC-E04C-40BA-A9B7-6E064578F514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742691" y="1168624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27432" tIns="22860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$</a:t>
          </a:r>
        </a:p>
      </cdr:txBody>
    </cdr:sp>
  </cdr:relSizeAnchor>
  <cdr:relSizeAnchor xmlns:cdr="http://schemas.openxmlformats.org/drawingml/2006/chartDrawing">
    <cdr:from>
      <cdr:x>0.47974</cdr:x>
      <cdr:y>0.3139</cdr:y>
    </cdr:from>
    <cdr:to>
      <cdr:x>0.47974</cdr:x>
      <cdr:y>0.3139</cdr:y>
    </cdr:to>
    <cdr:sp macro="" textlink="">
      <cdr:nvSpPr>
        <cdr:cNvPr id="29715" name="Text Box 19">
          <a:extLst xmlns:a="http://schemas.openxmlformats.org/drawingml/2006/main">
            <a:ext uri="{FF2B5EF4-FFF2-40B4-BE49-F238E27FC236}">
              <a16:creationId xmlns:a16="http://schemas.microsoft.com/office/drawing/2014/main" id="{2FC020D5-1B2D-40A3-A729-D6DE12EAA307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176197" y="872907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wrap="square" lIns="27432" tIns="22860" rIns="0" bIns="0" anchor="t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$</a:t>
          </a:r>
        </a:p>
      </cdr:txBody>
    </cdr:sp>
  </cdr:relSizeAnchor>
  <cdr:relSizeAnchor xmlns:cdr="http://schemas.openxmlformats.org/drawingml/2006/chartDrawing">
    <cdr:from>
      <cdr:x>0.57763</cdr:x>
      <cdr:y>0.27639</cdr:y>
    </cdr:from>
    <cdr:to>
      <cdr:x>0.57763</cdr:x>
      <cdr:y>0.27639</cdr:y>
    </cdr:to>
    <cdr:sp macro="" textlink="">
      <cdr:nvSpPr>
        <cdr:cNvPr id="29716" name="Text Box 20">
          <a:extLst xmlns:a="http://schemas.openxmlformats.org/drawingml/2006/main">
            <a:ext uri="{FF2B5EF4-FFF2-40B4-BE49-F238E27FC236}">
              <a16:creationId xmlns:a16="http://schemas.microsoft.com/office/drawing/2014/main" id="{E74870BD-4FCC-4739-BE70-BE2F1D9A0C68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620790" y="768299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80779</cdr:x>
      <cdr:y>0.33495</cdr:y>
    </cdr:from>
    <cdr:to>
      <cdr:x>0.98489</cdr:x>
      <cdr:y>0.41546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52751C6D-6F9F-4D87-BE6C-0D4C8FE5F665}"/>
            </a:ext>
          </a:extLst>
        </cdr:cNvPr>
        <cdr:cNvSpPr txBox="1"/>
      </cdr:nvSpPr>
      <cdr:spPr>
        <a:xfrm xmlns:a="http://schemas.openxmlformats.org/drawingml/2006/main">
          <a:off x="1867233" y="612676"/>
          <a:ext cx="409379" cy="14727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80627</cdr:x>
      <cdr:y>0.15019</cdr:y>
    </cdr:from>
    <cdr:to>
      <cdr:x>0.90913</cdr:x>
      <cdr:y>0.21686</cdr:y>
    </cdr:to>
    <cdr:sp macro="" textlink="">
      <cdr:nvSpPr>
        <cdr:cNvPr id="23" name="TextBox 1">
          <a:extLst xmlns:a="http://schemas.openxmlformats.org/drawingml/2006/main">
            <a:ext uri="{FF2B5EF4-FFF2-40B4-BE49-F238E27FC236}">
              <a16:creationId xmlns:a16="http://schemas.microsoft.com/office/drawing/2014/main" id="{B63964A3-4496-44EF-88D4-6E171AE111BF}"/>
            </a:ext>
          </a:extLst>
        </cdr:cNvPr>
        <cdr:cNvSpPr txBox="1"/>
      </cdr:nvSpPr>
      <cdr:spPr>
        <a:xfrm xmlns:a="http://schemas.openxmlformats.org/drawingml/2006/main">
          <a:off x="1863722" y="274725"/>
          <a:ext cx="237765" cy="1219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100" dirty="0"/>
            <a:t>**</a:t>
          </a:r>
        </a:p>
      </cdr:txBody>
    </cdr:sp>
  </cdr:relSizeAnchor>
  <cdr:relSizeAnchor xmlns:cdr="http://schemas.openxmlformats.org/drawingml/2006/chartDrawing">
    <cdr:from>
      <cdr:x>0.80583</cdr:x>
      <cdr:y>0.18735</cdr:y>
    </cdr:from>
    <cdr:to>
      <cdr:x>0.90869</cdr:x>
      <cdr:y>0.25402</cdr:y>
    </cdr:to>
    <cdr:sp macro="" textlink="">
      <cdr:nvSpPr>
        <cdr:cNvPr id="24" name="TextBox 1">
          <a:extLst xmlns:a="http://schemas.openxmlformats.org/drawingml/2006/main">
            <a:ext uri="{FF2B5EF4-FFF2-40B4-BE49-F238E27FC236}">
              <a16:creationId xmlns:a16="http://schemas.microsoft.com/office/drawing/2014/main" id="{24016034-1993-43C7-9003-B8E467B6322A}"/>
            </a:ext>
          </a:extLst>
        </cdr:cNvPr>
        <cdr:cNvSpPr txBox="1"/>
      </cdr:nvSpPr>
      <cdr:spPr>
        <a:xfrm xmlns:a="http://schemas.openxmlformats.org/drawingml/2006/main">
          <a:off x="1862701" y="342702"/>
          <a:ext cx="237764" cy="1219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100" dirty="0"/>
            <a:t>*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4661</cdr:x>
      <cdr:y>0.61755</cdr:y>
    </cdr:from>
    <cdr:to>
      <cdr:x>0.24661</cdr:x>
      <cdr:y>0.61755</cdr:y>
    </cdr:to>
    <cdr:sp macro="" textlink="">
      <cdr:nvSpPr>
        <cdr:cNvPr id="30721" name="Text Box 1">
          <a:extLst xmlns:a="http://schemas.openxmlformats.org/drawingml/2006/main">
            <a:ext uri="{FF2B5EF4-FFF2-40B4-BE49-F238E27FC236}">
              <a16:creationId xmlns:a16="http://schemas.microsoft.com/office/drawing/2014/main" id="{17A5D771-0C80-4672-B80B-8295E93E7D65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115546" y="1804467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3401</cdr:x>
      <cdr:y>0.61755</cdr:y>
    </cdr:from>
    <cdr:to>
      <cdr:x>0.3401</cdr:x>
      <cdr:y>0.61755</cdr:y>
    </cdr:to>
    <cdr:sp macro="" textlink="">
      <cdr:nvSpPr>
        <cdr:cNvPr id="30722" name="Text Box 2">
          <a:extLst xmlns:a="http://schemas.openxmlformats.org/drawingml/2006/main">
            <a:ext uri="{FF2B5EF4-FFF2-40B4-BE49-F238E27FC236}">
              <a16:creationId xmlns:a16="http://schemas.microsoft.com/office/drawing/2014/main" id="{D1AE32D9-EBE1-4AD5-B355-F637C576BD46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539453" y="1804467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25808</cdr:x>
      <cdr:y>0.6426</cdr:y>
    </cdr:from>
    <cdr:to>
      <cdr:x>0.25808</cdr:x>
      <cdr:y>0.6426</cdr:y>
    </cdr:to>
    <cdr:sp macro="" textlink="">
      <cdr:nvSpPr>
        <cdr:cNvPr id="30723" name="Text Box 3">
          <a:extLst xmlns:a="http://schemas.openxmlformats.org/drawingml/2006/main">
            <a:ext uri="{FF2B5EF4-FFF2-40B4-BE49-F238E27FC236}">
              <a16:creationId xmlns:a16="http://schemas.microsoft.com/office/drawing/2014/main" id="{0CBDA795-8248-466A-827C-485274F10E5A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167566" y="1877771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35084</cdr:x>
      <cdr:y>0.6426</cdr:y>
    </cdr:from>
    <cdr:to>
      <cdr:x>0.35084</cdr:x>
      <cdr:y>0.6426</cdr:y>
    </cdr:to>
    <cdr:sp macro="" textlink="">
      <cdr:nvSpPr>
        <cdr:cNvPr id="30724" name="Text Box 4">
          <a:extLst xmlns:a="http://schemas.openxmlformats.org/drawingml/2006/main">
            <a:ext uri="{FF2B5EF4-FFF2-40B4-BE49-F238E27FC236}">
              <a16:creationId xmlns:a16="http://schemas.microsoft.com/office/drawing/2014/main" id="{BF97023B-8085-464E-80E4-59C9E05CCBF3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588152" y="1877771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44654</cdr:x>
      <cdr:y>0.61755</cdr:y>
    </cdr:from>
    <cdr:to>
      <cdr:x>0.44654</cdr:x>
      <cdr:y>0.61755</cdr:y>
    </cdr:to>
    <cdr:sp macro="" textlink="">
      <cdr:nvSpPr>
        <cdr:cNvPr id="30725" name="Text Box 5">
          <a:extLst xmlns:a="http://schemas.openxmlformats.org/drawingml/2006/main">
            <a:ext uri="{FF2B5EF4-FFF2-40B4-BE49-F238E27FC236}">
              <a16:creationId xmlns:a16="http://schemas.microsoft.com/office/drawing/2014/main" id="{88134BEC-D7DF-4853-990B-B67DAB75D626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022020" y="1804467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  <cdr:relSizeAnchor xmlns:cdr="http://schemas.openxmlformats.org/drawingml/2006/chartDrawing">
    <cdr:from>
      <cdr:x>0.28859</cdr:x>
      <cdr:y>0.6426</cdr:y>
    </cdr:from>
    <cdr:to>
      <cdr:x>0.28859</cdr:x>
      <cdr:y>0.6426</cdr:y>
    </cdr:to>
    <cdr:sp macro="" textlink="">
      <cdr:nvSpPr>
        <cdr:cNvPr id="30726" name="Text Box 6">
          <a:extLst xmlns:a="http://schemas.openxmlformats.org/drawingml/2006/main">
            <a:ext uri="{FF2B5EF4-FFF2-40B4-BE49-F238E27FC236}">
              <a16:creationId xmlns:a16="http://schemas.microsoft.com/office/drawing/2014/main" id="{29115503-AB98-4688-9182-7A7C709BF5F7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305917" y="1877771"/>
          <a:ext cx="0" cy="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22860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fr-FR" sz="825" b="1" i="0" u="none" strike="noStrike" baseline="0">
              <a:solidFill>
                <a:srgbClr val="000000"/>
              </a:solidFill>
              <a:latin typeface="Arial"/>
              <a:cs typeface="Arial"/>
            </a:rPr>
            <a:t>$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3773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7143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918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845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1565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122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4203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150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271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1516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9059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2C131-F311-46C3-8EB3-5E9C7EE96A22}" type="datetimeFigureOut">
              <a:rPr lang="en-GB" smtClean="0"/>
              <a:t>04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8C609-5B03-4EF3-8069-17BF05D8B3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570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FF2EF9D-C541-4C05-95D1-52C7B671C431}"/>
              </a:ext>
            </a:extLst>
          </p:cNvPr>
          <p:cNvSpPr txBox="1"/>
          <p:nvPr/>
        </p:nvSpPr>
        <p:spPr>
          <a:xfrm>
            <a:off x="-28452" y="7744292"/>
            <a:ext cx="68580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/>
              <a:t>Supplementary figure 1 : PK profile of metformin and </a:t>
            </a:r>
            <a:r>
              <a:rPr lang="en-GB" sz="900" b="1" dirty="0" err="1"/>
              <a:t>Imeglimin</a:t>
            </a:r>
            <a:r>
              <a:rPr lang="en-GB" sz="900" b="1" dirty="0"/>
              <a:t> </a:t>
            </a:r>
            <a:r>
              <a:rPr lang="en-US" sz="900" b="1" dirty="0"/>
              <a:t>in open chest anesthetized mongrel dog. </a:t>
            </a:r>
            <a:endParaRPr lang="en-GB" sz="900" b="1" dirty="0"/>
          </a:p>
          <a:p>
            <a:pPr algn="just"/>
            <a:r>
              <a:rPr lang="en-GB" sz="900" dirty="0"/>
              <a:t>Plasma concentration of metformin and </a:t>
            </a:r>
            <a:r>
              <a:rPr lang="en-GB" sz="900" dirty="0" err="1"/>
              <a:t>Imeglimin</a:t>
            </a:r>
            <a:r>
              <a:rPr lang="en-GB" sz="900" dirty="0"/>
              <a:t> following intraduodenal injection of the drugs at 30, 100, 300 or 1000 mg/kg. Values shown represent mean of n = 5  animals per group.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2ECC56A8-A749-4763-846B-27B99C044C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706381"/>
              </p:ext>
            </p:extLst>
          </p:nvPr>
        </p:nvGraphicFramePr>
        <p:xfrm>
          <a:off x="45769" y="832548"/>
          <a:ext cx="3354779" cy="27488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EE7FA38C-6034-4D5C-BFF7-A40A77BD9B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7258245"/>
              </p:ext>
            </p:extLst>
          </p:nvPr>
        </p:nvGraphicFramePr>
        <p:xfrm>
          <a:off x="3368203" y="756347"/>
          <a:ext cx="3403664" cy="28250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7D5BB5DC-694E-48BD-9A71-8B95EB95DB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0309414"/>
              </p:ext>
            </p:extLst>
          </p:nvPr>
        </p:nvGraphicFramePr>
        <p:xfrm>
          <a:off x="1" y="4055953"/>
          <a:ext cx="3400548" cy="27488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7889B64C-AA7C-4848-9DEE-B8A0AED219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1236847"/>
              </p:ext>
            </p:extLst>
          </p:nvPr>
        </p:nvGraphicFramePr>
        <p:xfrm>
          <a:off x="3400548" y="4055953"/>
          <a:ext cx="3400549" cy="27488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24936575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9AC12D7C-6FAA-4679-B15D-34BC2B1A43E1}"/>
              </a:ext>
            </a:extLst>
          </p:cNvPr>
          <p:cNvSpPr txBox="1"/>
          <p:nvPr/>
        </p:nvSpPr>
        <p:spPr>
          <a:xfrm>
            <a:off x="-28452" y="7744292"/>
            <a:ext cx="6858000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/>
              <a:t>Supplementary figure 2 : Plasma lactate and calculated pH in Sprague Dawley rats with gentamicin induced mild renal failure (0.8 &lt; creatinine &lt; 1.99 mg/dL).</a:t>
            </a:r>
          </a:p>
          <a:p>
            <a:pPr algn="just"/>
            <a:r>
              <a:rPr lang="en-GB" sz="900" dirty="0"/>
              <a:t>Time course of plasma lactate concentration (mmol/L) and calculated pH from H</a:t>
            </a:r>
            <a:r>
              <a:rPr lang="en-GB" sz="900" baseline="30000" dirty="0"/>
              <a:t>+ </a:t>
            </a:r>
            <a:r>
              <a:rPr lang="en-GB" sz="900" dirty="0"/>
              <a:t>plasma concentration (units) during perfusion of </a:t>
            </a:r>
            <a:r>
              <a:rPr lang="en-GB" sz="900" b="1" dirty="0"/>
              <a:t>A)</a:t>
            </a:r>
            <a:r>
              <a:rPr lang="en-GB" sz="900" dirty="0"/>
              <a:t> metformin or </a:t>
            </a:r>
            <a:r>
              <a:rPr lang="en-GB" sz="900" b="1" dirty="0"/>
              <a:t>B)</a:t>
            </a:r>
            <a:r>
              <a:rPr lang="en-GB" sz="900" dirty="0"/>
              <a:t> </a:t>
            </a:r>
            <a:r>
              <a:rPr lang="en-GB" sz="900" dirty="0" err="1"/>
              <a:t>Imeglimin</a:t>
            </a:r>
            <a:r>
              <a:rPr lang="en-GB" sz="900" dirty="0"/>
              <a:t> at 25, 50, 75 or 100 mg/kg/h. </a:t>
            </a:r>
            <a:r>
              <a:rPr lang="en-US" sz="900" dirty="0"/>
              <a:t>Values shown represent mean + SEM of </a:t>
            </a:r>
            <a:r>
              <a:rPr lang="en-GB" sz="900" dirty="0"/>
              <a:t>n = 5-7 animals per group. * p&lt;0.05 ## ** p&lt;0.01 vs control at t150 min (Dunnett’s test)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60F570F-2A02-40D3-8FD2-7E4669D6627B}"/>
              </a:ext>
            </a:extLst>
          </p:cNvPr>
          <p:cNvSpPr txBox="1"/>
          <p:nvPr/>
        </p:nvSpPr>
        <p:spPr>
          <a:xfrm>
            <a:off x="-28575" y="427973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</a:p>
        </p:txBody>
      </p:sp>
      <p:graphicFrame>
        <p:nvGraphicFramePr>
          <p:cNvPr id="62" name="Chart 61">
            <a:extLst>
              <a:ext uri="{FF2B5EF4-FFF2-40B4-BE49-F238E27FC236}">
                <a16:creationId xmlns:a16="http://schemas.microsoft.com/office/drawing/2014/main" id="{3B030D69-2438-4BA0-B3F3-41352FC243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3932012"/>
              </p:ext>
            </p:extLst>
          </p:nvPr>
        </p:nvGraphicFramePr>
        <p:xfrm>
          <a:off x="257081" y="1431643"/>
          <a:ext cx="3210346" cy="24109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6" name="Chart 55">
            <a:extLst>
              <a:ext uri="{FF2B5EF4-FFF2-40B4-BE49-F238E27FC236}">
                <a16:creationId xmlns:a16="http://schemas.microsoft.com/office/drawing/2014/main" id="{B2EFB6E4-7AA5-4CD0-8213-BE7501D975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3801726"/>
              </p:ext>
            </p:extLst>
          </p:nvPr>
        </p:nvGraphicFramePr>
        <p:xfrm>
          <a:off x="414856" y="4279732"/>
          <a:ext cx="3014144" cy="24708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1" name="TextBox 60">
            <a:extLst>
              <a:ext uri="{FF2B5EF4-FFF2-40B4-BE49-F238E27FC236}">
                <a16:creationId xmlns:a16="http://schemas.microsoft.com/office/drawing/2014/main" id="{1CE09627-C859-4930-8B7A-81DB475F76D7}"/>
              </a:ext>
            </a:extLst>
          </p:cNvPr>
          <p:cNvSpPr txBox="1"/>
          <p:nvPr/>
        </p:nvSpPr>
        <p:spPr>
          <a:xfrm>
            <a:off x="-47175" y="1303196"/>
            <a:ext cx="231515" cy="31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436CDDB-4FD4-45AD-A9C3-DA762FEE55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92960" y="1485159"/>
            <a:ext cx="3407959" cy="238374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B8C409A-32CB-4BD7-8FB8-789A4716E5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8865" y="4533732"/>
            <a:ext cx="3286029" cy="2243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0031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81E0A28-0204-4B9A-8D4E-66FC3FAFF1D0}"/>
              </a:ext>
            </a:extLst>
          </p:cNvPr>
          <p:cNvSpPr txBox="1"/>
          <p:nvPr/>
        </p:nvSpPr>
        <p:spPr>
          <a:xfrm>
            <a:off x="0" y="4953000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/>
              <a:t>Supplementary figure 3 : Plasma </a:t>
            </a:r>
            <a:r>
              <a:rPr lang="en-GB" sz="900" b="1"/>
              <a:t>concentration vs. </a:t>
            </a:r>
            <a:r>
              <a:rPr lang="en-GB" sz="900" b="1" dirty="0"/>
              <a:t>dose of metformin and </a:t>
            </a:r>
            <a:r>
              <a:rPr lang="en-GB" sz="900" b="1" dirty="0" err="1"/>
              <a:t>Imeglimin</a:t>
            </a:r>
            <a:r>
              <a:rPr lang="en-GB" sz="900" b="1" dirty="0"/>
              <a:t> </a:t>
            </a:r>
            <a:r>
              <a:rPr lang="en-US" sz="900" b="1" dirty="0"/>
              <a:t>in Sprague Dawley rats with gentamicin induced mild (0.8 &lt; creatinine &lt; 1.99 mg/dL) and severe (creatine &gt; 2 mg/dL) renal failure.</a:t>
            </a:r>
          </a:p>
          <a:p>
            <a:pPr algn="just"/>
            <a:r>
              <a:rPr lang="en-GB" sz="900" dirty="0"/>
              <a:t>Plasma concentration of metformin and </a:t>
            </a:r>
            <a:r>
              <a:rPr lang="en-GB" sz="900" dirty="0" err="1"/>
              <a:t>Imeglimin</a:t>
            </a:r>
            <a:r>
              <a:rPr lang="en-GB" sz="900" dirty="0"/>
              <a:t> following 180 min of infusion of the drugs at 25, 50, 75 or 100 mg/kg/h for a final dose of 75, 150, 225 and 300 mg/kg, respectively (x axis). Values shown represent mean of n = 2-6  animals per group. 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BD3F55DC-63BB-4EE0-8DCC-474762BD24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8511902"/>
              </p:ext>
            </p:extLst>
          </p:nvPr>
        </p:nvGraphicFramePr>
        <p:xfrm>
          <a:off x="49685" y="1015439"/>
          <a:ext cx="3296765" cy="24580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625B61F9-4CDB-46BD-AD98-5F6BE7EDC6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264997"/>
              </p:ext>
            </p:extLst>
          </p:nvPr>
        </p:nvGraphicFramePr>
        <p:xfrm>
          <a:off x="3282950" y="1002178"/>
          <a:ext cx="3487265" cy="25622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771773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9B2E599DD8BAD44C87DEB0A9214A5D65" ma:contentTypeVersion="8" ma:contentTypeDescription="新しいドキュメントを作成します。" ma:contentTypeScope="" ma:versionID="7b65157c5604f525985aecc5e811160e">
  <xsd:schema xmlns:xsd="http://www.w3.org/2001/XMLSchema" xmlns:xs="http://www.w3.org/2001/XMLSchema" xmlns:p="http://schemas.microsoft.com/office/2006/metadata/properties" xmlns:ns2="4a0e8444-1d05-4b22-8250-cde356d814a9" targetNamespace="http://schemas.microsoft.com/office/2006/metadata/properties" ma:root="true" ma:fieldsID="13e7f29fd8751d2c84c0111b1c6d9f9f" ns2:_="">
    <xsd:import namespace="4a0e8444-1d05-4b22-8250-cde356d814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a0e8444-1d05-4b22-8250-cde356d814a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7D9FCF4-64E7-4DBE-AAE4-27310A9C9A15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4a0e8444-1d05-4b22-8250-cde356d814a9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62BD65F5-BB42-4720-9862-A568916BACF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72D3F8E-E953-4D04-A2C3-C7E28676DD9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a0e8444-1d05-4b22-8250-cde356d814a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191</TotalTime>
  <Words>411</Words>
  <Application>Microsoft Office PowerPoint</Application>
  <PresentationFormat>A4 Paper (210x297 mm)</PresentationFormat>
  <Paragraphs>5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erre THEUREY</dc:creator>
  <cp:lastModifiedBy>Pierre THEUREY</cp:lastModifiedBy>
  <cp:revision>343</cp:revision>
  <cp:lastPrinted>2021-08-25T16:43:01Z</cp:lastPrinted>
  <dcterms:created xsi:type="dcterms:W3CDTF">2021-05-25T08:04:33Z</dcterms:created>
  <dcterms:modified xsi:type="dcterms:W3CDTF">2021-10-04T14:16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2E599DD8BAD44C87DEB0A9214A5D65</vt:lpwstr>
  </property>
</Properties>
</file>